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1" r:id="rId2"/>
    <p:sldId id="286" r:id="rId3"/>
    <p:sldId id="265" r:id="rId4"/>
    <p:sldId id="263" r:id="rId5"/>
    <p:sldId id="264" r:id="rId6"/>
    <p:sldId id="266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0" autoAdjust="0"/>
    <p:restoredTop sz="95392" autoAdjust="0"/>
  </p:normalViewPr>
  <p:slideViewPr>
    <p:cSldViewPr snapToGrid="0">
      <p:cViewPr varScale="1">
        <p:scale>
          <a:sx n="66" d="100"/>
          <a:sy n="66" d="100"/>
        </p:scale>
        <p:origin x="292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10" d="100"/>
        <a:sy n="110" d="100"/>
      </p:scale>
      <p:origin x="0" y="-19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sca Trespidi" userId="fcf5a3d0aaa41ee2" providerId="LiveId" clId="{7614391D-DE7E-4F76-8922-D2DB3F3D93D6}"/>
    <pc:docChg chg="undo custSel addSld delSld modSld sldOrd">
      <pc:chgData name="Francesca Trespidi" userId="fcf5a3d0aaa41ee2" providerId="LiveId" clId="{7614391D-DE7E-4F76-8922-D2DB3F3D93D6}" dt="2025-08-12T10:40:31.673" v="488" actId="47"/>
      <pc:docMkLst>
        <pc:docMk/>
      </pc:docMkLst>
      <pc:sldChg chg="del">
        <pc:chgData name="Francesca Trespidi" userId="fcf5a3d0aaa41ee2" providerId="LiveId" clId="{7614391D-DE7E-4F76-8922-D2DB3F3D93D6}" dt="2025-08-11T15:18:31.869" v="17" actId="47"/>
        <pc:sldMkLst>
          <pc:docMk/>
          <pc:sldMk cId="2878836773" sldId="262"/>
        </pc:sldMkLst>
      </pc:sldChg>
      <pc:sldChg chg="addSp delSp modSp mod">
        <pc:chgData name="Francesca Trespidi" userId="fcf5a3d0aaa41ee2" providerId="LiveId" clId="{7614391D-DE7E-4F76-8922-D2DB3F3D93D6}" dt="2025-08-11T15:22:05.401" v="43" actId="1076"/>
        <pc:sldMkLst>
          <pc:docMk/>
          <pc:sldMk cId="2743029292" sldId="263"/>
        </pc:sldMkLst>
        <pc:picChg chg="add mod">
          <ac:chgData name="Francesca Trespidi" userId="fcf5a3d0aaa41ee2" providerId="LiveId" clId="{7614391D-DE7E-4F76-8922-D2DB3F3D93D6}" dt="2025-08-11T15:22:05.401" v="43" actId="1076"/>
          <ac:picMkLst>
            <pc:docMk/>
            <pc:sldMk cId="2743029292" sldId="263"/>
            <ac:picMk id="2" creationId="{CA4FCC6C-37C0-19D8-D808-147A27CC24E2}"/>
          </ac:picMkLst>
        </pc:picChg>
        <pc:picChg chg="del">
          <ac:chgData name="Francesca Trespidi" userId="fcf5a3d0aaa41ee2" providerId="LiveId" clId="{7614391D-DE7E-4F76-8922-D2DB3F3D93D6}" dt="2025-08-11T15:21:56.945" v="39" actId="478"/>
          <ac:picMkLst>
            <pc:docMk/>
            <pc:sldMk cId="2743029292" sldId="263"/>
            <ac:picMk id="16" creationId="{8259FB36-B015-0D3B-B191-4B8414BE6C06}"/>
          </ac:picMkLst>
        </pc:picChg>
      </pc:sldChg>
      <pc:sldChg chg="addSp delSp modSp mod">
        <pc:chgData name="Francesca Trespidi" userId="fcf5a3d0aaa41ee2" providerId="LiveId" clId="{7614391D-DE7E-4F76-8922-D2DB3F3D93D6}" dt="2025-08-11T15:34:12.662" v="58" actId="14100"/>
        <pc:sldMkLst>
          <pc:docMk/>
          <pc:sldMk cId="995961952" sldId="264"/>
        </pc:sldMkLst>
        <pc:picChg chg="del">
          <ac:chgData name="Francesca Trespidi" userId="fcf5a3d0aaa41ee2" providerId="LiveId" clId="{7614391D-DE7E-4F76-8922-D2DB3F3D93D6}" dt="2025-08-11T15:34:05.197" v="55" actId="478"/>
          <ac:picMkLst>
            <pc:docMk/>
            <pc:sldMk cId="995961952" sldId="264"/>
            <ac:picMk id="5" creationId="{D7727730-1CD1-CF0F-0B82-1C72CC81C9EE}"/>
          </ac:picMkLst>
        </pc:picChg>
        <pc:picChg chg="add mod">
          <ac:chgData name="Francesca Trespidi" userId="fcf5a3d0aaa41ee2" providerId="LiveId" clId="{7614391D-DE7E-4F76-8922-D2DB3F3D93D6}" dt="2025-08-11T15:34:12.662" v="58" actId="14100"/>
          <ac:picMkLst>
            <pc:docMk/>
            <pc:sldMk cId="995961952" sldId="264"/>
            <ac:picMk id="8" creationId="{14D0723F-D73A-D16A-9515-5AA2684340F8}"/>
          </ac:picMkLst>
        </pc:picChg>
      </pc:sldChg>
      <pc:sldChg chg="addSp delSp modSp mod">
        <pc:chgData name="Francesca Trespidi" userId="fcf5a3d0aaa41ee2" providerId="LiveId" clId="{7614391D-DE7E-4F76-8922-D2DB3F3D93D6}" dt="2025-08-11T15:20:30.779" v="33" actId="1076"/>
        <pc:sldMkLst>
          <pc:docMk/>
          <pc:sldMk cId="3150382344" sldId="265"/>
        </pc:sldMkLst>
        <pc:spChg chg="mod">
          <ac:chgData name="Francesca Trespidi" userId="fcf5a3d0aaa41ee2" providerId="LiveId" clId="{7614391D-DE7E-4F76-8922-D2DB3F3D93D6}" dt="2025-08-11T15:20:30.779" v="33" actId="1076"/>
          <ac:spMkLst>
            <pc:docMk/>
            <pc:sldMk cId="3150382344" sldId="265"/>
            <ac:spMk id="7" creationId="{9DD0951B-D963-4401-972A-29E970FB00A6}"/>
          </ac:spMkLst>
        </pc:spChg>
        <pc:picChg chg="add">
          <ac:chgData name="Francesca Trespidi" userId="fcf5a3d0aaa41ee2" providerId="LiveId" clId="{7614391D-DE7E-4F76-8922-D2DB3F3D93D6}" dt="2025-08-11T15:20:09.589" v="28"/>
          <ac:picMkLst>
            <pc:docMk/>
            <pc:sldMk cId="3150382344" sldId="265"/>
            <ac:picMk id="2" creationId="{3C38F079-6FD5-F40B-7893-719C5C3C2598}"/>
          </ac:picMkLst>
        </pc:picChg>
        <pc:picChg chg="add mod">
          <ac:chgData name="Francesca Trespidi" userId="fcf5a3d0aaa41ee2" providerId="LiveId" clId="{7614391D-DE7E-4F76-8922-D2DB3F3D93D6}" dt="2025-08-11T15:20:27.426" v="32" actId="14100"/>
          <ac:picMkLst>
            <pc:docMk/>
            <pc:sldMk cId="3150382344" sldId="265"/>
            <ac:picMk id="5" creationId="{A2D6E613-49BD-1FE4-9EBD-FAB586423914}"/>
          </ac:picMkLst>
        </pc:picChg>
        <pc:picChg chg="del">
          <ac:chgData name="Francesca Trespidi" userId="fcf5a3d0aaa41ee2" providerId="LiveId" clId="{7614391D-DE7E-4F76-8922-D2DB3F3D93D6}" dt="2025-08-11T15:20:04.923" v="26" actId="478"/>
          <ac:picMkLst>
            <pc:docMk/>
            <pc:sldMk cId="3150382344" sldId="265"/>
            <ac:picMk id="9" creationId="{4337AD83-41B5-A142-8668-4DD16DF9D781}"/>
          </ac:picMkLst>
        </pc:picChg>
      </pc:sldChg>
      <pc:sldChg chg="addSp delSp modSp mod">
        <pc:chgData name="Francesca Trespidi" userId="fcf5a3d0aaa41ee2" providerId="LiveId" clId="{7614391D-DE7E-4F76-8922-D2DB3F3D93D6}" dt="2025-08-11T16:39:18.300" v="113" actId="1076"/>
        <pc:sldMkLst>
          <pc:docMk/>
          <pc:sldMk cId="4072870624" sldId="266"/>
        </pc:sldMkLst>
        <pc:spChg chg="mod">
          <ac:chgData name="Francesca Trespidi" userId="fcf5a3d0aaa41ee2" providerId="LiveId" clId="{7614391D-DE7E-4F76-8922-D2DB3F3D93D6}" dt="2025-08-11T16:39:18.300" v="113" actId="1076"/>
          <ac:spMkLst>
            <pc:docMk/>
            <pc:sldMk cId="4072870624" sldId="266"/>
            <ac:spMk id="4" creationId="{D32B081D-1B61-CE63-CE63-F6762F9CFC0D}"/>
          </ac:spMkLst>
        </pc:spChg>
        <pc:grpChg chg="add mod">
          <ac:chgData name="Francesca Trespidi" userId="fcf5a3d0aaa41ee2" providerId="LiveId" clId="{7614391D-DE7E-4F76-8922-D2DB3F3D93D6}" dt="2025-08-11T16:39:03.182" v="112" actId="1076"/>
          <ac:grpSpMkLst>
            <pc:docMk/>
            <pc:sldMk cId="4072870624" sldId="266"/>
            <ac:grpSpMk id="16" creationId="{6D9C392D-3670-5740-FA50-B7042A09E46A}"/>
          </ac:grpSpMkLst>
        </pc:grp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2" creationId="{855DE70D-4073-D630-7276-B1642E614E60}"/>
          </ac:picMkLst>
        </pc:picChg>
        <pc:picChg chg="del">
          <ac:chgData name="Francesca Trespidi" userId="fcf5a3d0aaa41ee2" providerId="LiveId" clId="{7614391D-DE7E-4F76-8922-D2DB3F3D93D6}" dt="2025-08-11T16:38:48.389" v="109" actId="478"/>
          <ac:picMkLst>
            <pc:docMk/>
            <pc:sldMk cId="4072870624" sldId="266"/>
            <ac:picMk id="10" creationId="{7FE21C29-D3D2-FEE7-FBF0-829F47C47DD1}"/>
          </ac:picMkLst>
        </pc:pic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11" creationId="{55047B20-A26C-DAFB-947B-C6EFA8E6CAAE}"/>
          </ac:picMkLst>
        </pc:pic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12" creationId="{784099A1-20E1-4F54-3CA7-ABED85F0A8B2}"/>
          </ac:picMkLst>
        </pc:pic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13" creationId="{DE639872-EA93-444B-03B0-FC153088C006}"/>
          </ac:picMkLst>
        </pc:pic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14" creationId="{A90DB188-0367-B598-409F-A1DD954E24FC}"/>
          </ac:picMkLst>
        </pc:picChg>
        <pc:picChg chg="add mod">
          <ac:chgData name="Francesca Trespidi" userId="fcf5a3d0aaa41ee2" providerId="LiveId" clId="{7614391D-DE7E-4F76-8922-D2DB3F3D93D6}" dt="2025-08-11T16:38:57.966" v="111" actId="164"/>
          <ac:picMkLst>
            <pc:docMk/>
            <pc:sldMk cId="4072870624" sldId="266"/>
            <ac:picMk id="15" creationId="{C2B24A2E-84A9-B4EA-A886-D7887EB05CD0}"/>
          </ac:picMkLst>
        </pc:picChg>
      </pc:sldChg>
      <pc:sldChg chg="addSp delSp modSp mod">
        <pc:chgData name="Francesca Trespidi" userId="fcf5a3d0aaa41ee2" providerId="LiveId" clId="{7614391D-DE7E-4F76-8922-D2DB3F3D93D6}" dt="2025-08-11T17:19:32.098" v="341" actId="164"/>
        <pc:sldMkLst>
          <pc:docMk/>
          <pc:sldMk cId="140177626" sldId="269"/>
        </pc:sldMkLst>
        <pc:spChg chg="mod">
          <ac:chgData name="Francesca Trespidi" userId="fcf5a3d0aaa41ee2" providerId="LiveId" clId="{7614391D-DE7E-4F76-8922-D2DB3F3D93D6}" dt="2025-08-11T16:57:46.898" v="233" actId="164"/>
          <ac:spMkLst>
            <pc:docMk/>
            <pc:sldMk cId="140177626" sldId="269"/>
            <ac:spMk id="3" creationId="{74C174FD-76FF-2960-5BCB-D044E7F0CA95}"/>
          </ac:spMkLst>
        </pc:spChg>
        <pc:spChg chg="mod">
          <ac:chgData name="Francesca Trespidi" userId="fcf5a3d0aaa41ee2" providerId="LiveId" clId="{7614391D-DE7E-4F76-8922-D2DB3F3D93D6}" dt="2025-08-11T17:14:36.541" v="318" actId="1076"/>
          <ac:spMkLst>
            <pc:docMk/>
            <pc:sldMk cId="140177626" sldId="269"/>
            <ac:spMk id="4" creationId="{90DBF701-93AF-58B6-374F-4A1F947D564C}"/>
          </ac:spMkLst>
        </pc:spChg>
        <pc:spChg chg="mod">
          <ac:chgData name="Francesca Trespidi" userId="fcf5a3d0aaa41ee2" providerId="LiveId" clId="{7614391D-DE7E-4F76-8922-D2DB3F3D93D6}" dt="2025-08-11T16:57:46.898" v="233" actId="164"/>
          <ac:spMkLst>
            <pc:docMk/>
            <pc:sldMk cId="140177626" sldId="269"/>
            <ac:spMk id="5" creationId="{BBCCD5F3-BD33-8ED8-3666-292FB3E3983E}"/>
          </ac:spMkLst>
        </pc:spChg>
        <pc:spChg chg="mod">
          <ac:chgData name="Francesca Trespidi" userId="fcf5a3d0aaa41ee2" providerId="LiveId" clId="{7614391D-DE7E-4F76-8922-D2DB3F3D93D6}" dt="2025-08-11T16:57:46.898" v="233" actId="164"/>
          <ac:spMkLst>
            <pc:docMk/>
            <pc:sldMk cId="140177626" sldId="269"/>
            <ac:spMk id="6" creationId="{9E9200D5-301C-9CE0-DF56-AF9B2D6F2E65}"/>
          </ac:spMkLst>
        </pc:spChg>
        <pc:spChg chg="mod">
          <ac:chgData name="Francesca Trespidi" userId="fcf5a3d0aaa41ee2" providerId="LiveId" clId="{7614391D-DE7E-4F76-8922-D2DB3F3D93D6}" dt="2025-08-11T16:57:46.898" v="233" actId="164"/>
          <ac:spMkLst>
            <pc:docMk/>
            <pc:sldMk cId="140177626" sldId="269"/>
            <ac:spMk id="7" creationId="{2128F1A4-F2A2-A77D-B777-079C7C1FC71B}"/>
          </ac:spMkLst>
        </pc:spChg>
        <pc:spChg chg="mod">
          <ac:chgData name="Francesca Trespidi" userId="fcf5a3d0aaa41ee2" providerId="LiveId" clId="{7614391D-DE7E-4F76-8922-D2DB3F3D93D6}" dt="2025-08-11T16:57:46.898" v="233" actId="164"/>
          <ac:spMkLst>
            <pc:docMk/>
            <pc:sldMk cId="140177626" sldId="269"/>
            <ac:spMk id="8" creationId="{8BE1D5CE-BCE2-EDEF-4944-E313E58D01B7}"/>
          </ac:spMkLst>
        </pc:spChg>
        <pc:spChg chg="mod">
          <ac:chgData name="Francesca Trespidi" userId="fcf5a3d0aaa41ee2" providerId="LiveId" clId="{7614391D-DE7E-4F76-8922-D2DB3F3D93D6}" dt="2025-08-11T16:57:34.273" v="231" actId="1076"/>
          <ac:spMkLst>
            <pc:docMk/>
            <pc:sldMk cId="140177626" sldId="269"/>
            <ac:spMk id="10" creationId="{8A877313-A886-66E1-F618-686445488339}"/>
          </ac:spMkLst>
        </pc:spChg>
        <pc:spChg chg="add mod">
          <ac:chgData name="Francesca Trespidi" userId="fcf5a3d0aaa41ee2" providerId="LiveId" clId="{7614391D-DE7E-4F76-8922-D2DB3F3D93D6}" dt="2025-08-11T17:18:39.857" v="325"/>
          <ac:spMkLst>
            <pc:docMk/>
            <pc:sldMk cId="140177626" sldId="269"/>
            <ac:spMk id="23" creationId="{8A68FE56-B983-1298-B520-DF4119B3DAF2}"/>
          </ac:spMkLst>
        </pc:spChg>
        <pc:spChg chg="add mod">
          <ac:chgData name="Francesca Trespidi" userId="fcf5a3d0aaa41ee2" providerId="LiveId" clId="{7614391D-DE7E-4F76-8922-D2DB3F3D93D6}" dt="2025-08-11T17:18:39.857" v="325"/>
          <ac:spMkLst>
            <pc:docMk/>
            <pc:sldMk cId="140177626" sldId="269"/>
            <ac:spMk id="25" creationId="{D6C845FF-F784-EDDA-BD26-3092B6C3DDEF}"/>
          </ac:spMkLst>
        </pc:spChg>
        <pc:grpChg chg="mod">
          <ac:chgData name="Francesca Trespidi" userId="fcf5a3d0aaa41ee2" providerId="LiveId" clId="{7614391D-DE7E-4F76-8922-D2DB3F3D93D6}" dt="2025-08-11T17:19:32.098" v="341" actId="164"/>
          <ac:grpSpMkLst>
            <pc:docMk/>
            <pc:sldMk cId="140177626" sldId="269"/>
            <ac:grpSpMk id="17" creationId="{15DF877C-50FE-3079-F7B9-66882797DDD3}"/>
          </ac:grpSpMkLst>
        </pc:grpChg>
        <pc:grpChg chg="add mod">
          <ac:chgData name="Francesca Trespidi" userId="fcf5a3d0aaa41ee2" providerId="LiveId" clId="{7614391D-DE7E-4F76-8922-D2DB3F3D93D6}" dt="2025-08-11T17:19:32.098" v="341" actId="164"/>
          <ac:grpSpMkLst>
            <pc:docMk/>
            <pc:sldMk cId="140177626" sldId="269"/>
            <ac:grpSpMk id="27" creationId="{75E72C4D-88AC-ED85-DF6C-6D529D43242B}"/>
          </ac:grpSpMkLst>
        </pc:grpChg>
        <pc:picChg chg="add del mod">
          <ac:chgData name="Francesca Trespidi" userId="fcf5a3d0aaa41ee2" providerId="LiveId" clId="{7614391D-DE7E-4F76-8922-D2DB3F3D93D6}" dt="2025-08-11T16:56:11.938" v="213" actId="21"/>
          <ac:picMkLst>
            <pc:docMk/>
            <pc:sldMk cId="140177626" sldId="269"/>
            <ac:picMk id="9" creationId="{A83D8480-4978-F176-B26E-D28009DF1709}"/>
          </ac:picMkLst>
        </pc:picChg>
        <pc:picChg chg="add mod">
          <ac:chgData name="Francesca Trespidi" userId="fcf5a3d0aaa41ee2" providerId="LiveId" clId="{7614391D-DE7E-4F76-8922-D2DB3F3D93D6}" dt="2025-08-11T16:57:46.898" v="233" actId="164"/>
          <ac:picMkLst>
            <pc:docMk/>
            <pc:sldMk cId="140177626" sldId="269"/>
            <ac:picMk id="11" creationId="{2B14B755-D1C5-5C8F-526D-263A6AEE5A82}"/>
          </ac:picMkLst>
        </pc:picChg>
        <pc:picChg chg="add mod">
          <ac:chgData name="Francesca Trespidi" userId="fcf5a3d0aaa41ee2" providerId="LiveId" clId="{7614391D-DE7E-4F76-8922-D2DB3F3D93D6}" dt="2025-08-11T16:57:46.898" v="233" actId="164"/>
          <ac:picMkLst>
            <pc:docMk/>
            <pc:sldMk cId="140177626" sldId="269"/>
            <ac:picMk id="12" creationId="{D739E934-CE2A-01AD-28A1-6886F57F7201}"/>
          </ac:picMkLst>
        </pc:picChg>
        <pc:picChg chg="add mod">
          <ac:chgData name="Francesca Trespidi" userId="fcf5a3d0aaa41ee2" providerId="LiveId" clId="{7614391D-DE7E-4F76-8922-D2DB3F3D93D6}" dt="2025-08-11T16:57:46.898" v="233" actId="164"/>
          <ac:picMkLst>
            <pc:docMk/>
            <pc:sldMk cId="140177626" sldId="269"/>
            <ac:picMk id="13" creationId="{8EEA4B2F-3EAD-AA5A-76C1-B778812A8030}"/>
          </ac:picMkLst>
        </pc:picChg>
        <pc:picChg chg="add mod">
          <ac:chgData name="Francesca Trespidi" userId="fcf5a3d0aaa41ee2" providerId="LiveId" clId="{7614391D-DE7E-4F76-8922-D2DB3F3D93D6}" dt="2025-08-11T16:57:08.220" v="222" actId="1076"/>
          <ac:picMkLst>
            <pc:docMk/>
            <pc:sldMk cId="140177626" sldId="269"/>
            <ac:picMk id="14" creationId="{F544BCE4-3366-F2D0-4780-D6FE595874DA}"/>
          </ac:picMkLst>
        </pc:picChg>
        <pc:picChg chg="add mod">
          <ac:chgData name="Francesca Trespidi" userId="fcf5a3d0aaa41ee2" providerId="LiveId" clId="{7614391D-DE7E-4F76-8922-D2DB3F3D93D6}" dt="2025-08-11T16:57:46.898" v="233" actId="164"/>
          <ac:picMkLst>
            <pc:docMk/>
            <pc:sldMk cId="140177626" sldId="269"/>
            <ac:picMk id="15" creationId="{DB228CCE-C10B-F62E-9877-B142012527B0}"/>
          </ac:picMkLst>
        </pc:picChg>
        <pc:picChg chg="add mod ord">
          <ac:chgData name="Francesca Trespidi" userId="fcf5a3d0aaa41ee2" providerId="LiveId" clId="{7614391D-DE7E-4F76-8922-D2DB3F3D93D6}" dt="2025-08-11T17:14:21.090" v="316" actId="167"/>
          <ac:picMkLst>
            <pc:docMk/>
            <pc:sldMk cId="140177626" sldId="269"/>
            <ac:picMk id="16" creationId="{0063CBE7-3963-DB4D-5F54-863B46E574D7}"/>
          </ac:picMkLst>
        </pc:picChg>
        <pc:picChg chg="add mod modCrop">
          <ac:chgData name="Francesca Trespidi" userId="fcf5a3d0aaa41ee2" providerId="LiveId" clId="{7614391D-DE7E-4F76-8922-D2DB3F3D93D6}" dt="2025-08-11T17:19:32.098" v="341" actId="164"/>
          <ac:picMkLst>
            <pc:docMk/>
            <pc:sldMk cId="140177626" sldId="269"/>
            <ac:picMk id="19" creationId="{F51107FE-AA8F-E0D7-CDEB-CF204B209A5C}"/>
          </ac:picMkLst>
        </pc:picChg>
        <pc:picChg chg="add">
          <ac:chgData name="Francesca Trespidi" userId="fcf5a3d0aaa41ee2" providerId="LiveId" clId="{7614391D-DE7E-4F76-8922-D2DB3F3D93D6}" dt="2025-08-11T17:18:37.371" v="324"/>
          <ac:picMkLst>
            <pc:docMk/>
            <pc:sldMk cId="140177626" sldId="269"/>
            <ac:picMk id="20" creationId="{2246EDB2-903B-8A1B-7AFC-39BA375DFFA9}"/>
          </ac:picMkLst>
        </pc:picChg>
        <pc:picChg chg="del">
          <ac:chgData name="Francesca Trespidi" userId="fcf5a3d0aaa41ee2" providerId="LiveId" clId="{7614391D-DE7E-4F76-8922-D2DB3F3D93D6}" dt="2025-08-11T16:56:54.943" v="220" actId="478"/>
          <ac:picMkLst>
            <pc:docMk/>
            <pc:sldMk cId="140177626" sldId="269"/>
            <ac:picMk id="21" creationId="{A3F5301E-29CA-0B8F-E49E-20F51BB73FB2}"/>
          </ac:picMkLst>
        </pc:picChg>
        <pc:picChg chg="add mod modCrop">
          <ac:chgData name="Francesca Trespidi" userId="fcf5a3d0aaa41ee2" providerId="LiveId" clId="{7614391D-DE7E-4F76-8922-D2DB3F3D93D6}" dt="2025-08-11T17:19:32.098" v="341" actId="164"/>
          <ac:picMkLst>
            <pc:docMk/>
            <pc:sldMk cId="140177626" sldId="269"/>
            <ac:picMk id="26" creationId="{215D3CC0-7CD5-FBA2-8D6C-A8E0C2B09F99}"/>
          </ac:picMkLst>
        </pc:picChg>
        <pc:cxnChg chg="add mod">
          <ac:chgData name="Francesca Trespidi" userId="fcf5a3d0aaa41ee2" providerId="LiveId" clId="{7614391D-DE7E-4F76-8922-D2DB3F3D93D6}" dt="2025-08-11T17:18:39.857" v="325"/>
          <ac:cxnSpMkLst>
            <pc:docMk/>
            <pc:sldMk cId="140177626" sldId="269"/>
            <ac:cxnSpMk id="22" creationId="{7C9A14B6-2643-5DC8-3CF8-5802238DCB50}"/>
          </ac:cxnSpMkLst>
        </pc:cxnChg>
        <pc:cxnChg chg="add mod">
          <ac:chgData name="Francesca Trespidi" userId="fcf5a3d0aaa41ee2" providerId="LiveId" clId="{7614391D-DE7E-4F76-8922-D2DB3F3D93D6}" dt="2025-08-11T17:18:39.857" v="325"/>
          <ac:cxnSpMkLst>
            <pc:docMk/>
            <pc:sldMk cId="140177626" sldId="269"/>
            <ac:cxnSpMk id="24" creationId="{C0C7584F-6FAA-D12B-AE94-289B55BFAF4A}"/>
          </ac:cxnSpMkLst>
        </pc:cxnChg>
      </pc:sldChg>
      <pc:sldChg chg="addSp delSp modSp mod ord">
        <pc:chgData name="Francesca Trespidi" userId="fcf5a3d0aaa41ee2" providerId="LiveId" clId="{7614391D-DE7E-4F76-8922-D2DB3F3D93D6}" dt="2025-08-12T09:31:22.384" v="421" actId="1076"/>
        <pc:sldMkLst>
          <pc:docMk/>
          <pc:sldMk cId="1940470235" sldId="283"/>
        </pc:sldMkLst>
        <pc:spChg chg="mod">
          <ac:chgData name="Francesca Trespidi" userId="fcf5a3d0aaa41ee2" providerId="LiveId" clId="{7614391D-DE7E-4F76-8922-D2DB3F3D93D6}" dt="2025-08-11T17:05:48.575" v="287" actId="1076"/>
          <ac:spMkLst>
            <pc:docMk/>
            <pc:sldMk cId="1940470235" sldId="283"/>
            <ac:spMk id="2" creationId="{4CF04094-96F2-1A95-0044-6F6961B76F27}"/>
          </ac:spMkLst>
        </pc:spChg>
        <pc:spChg chg="del">
          <ac:chgData name="Francesca Trespidi" userId="fcf5a3d0aaa41ee2" providerId="LiveId" clId="{7614391D-DE7E-4F76-8922-D2DB3F3D93D6}" dt="2025-08-11T17:05:18.275" v="277" actId="478"/>
          <ac:spMkLst>
            <pc:docMk/>
            <pc:sldMk cId="1940470235" sldId="283"/>
            <ac:spMk id="9" creationId="{70D19BE9-FAE8-DC09-8A80-6916FD2D4642}"/>
          </ac:spMkLst>
        </pc:spChg>
        <pc:spChg chg="mod ord">
          <ac:chgData name="Francesca Trespidi" userId="fcf5a3d0aaa41ee2" providerId="LiveId" clId="{7614391D-DE7E-4F76-8922-D2DB3F3D93D6}" dt="2025-08-11T17:05:36.792" v="284" actId="166"/>
          <ac:spMkLst>
            <pc:docMk/>
            <pc:sldMk cId="1940470235" sldId="283"/>
            <ac:spMk id="13" creationId="{05475377-E984-AFED-F69E-94BF19BFEBBF}"/>
          </ac:spMkLst>
        </pc:spChg>
        <pc:spChg chg="mod">
          <ac:chgData name="Francesca Trespidi" userId="fcf5a3d0aaa41ee2" providerId="LiveId" clId="{7614391D-DE7E-4F76-8922-D2DB3F3D93D6}" dt="2025-08-11T17:05:44.536" v="286" actId="1076"/>
          <ac:spMkLst>
            <pc:docMk/>
            <pc:sldMk cId="1940470235" sldId="283"/>
            <ac:spMk id="14" creationId="{700DA3C8-FE80-0C15-513E-244CF06A2FC1}"/>
          </ac:spMkLst>
        </pc:spChg>
        <pc:spChg chg="mod">
          <ac:chgData name="Francesca Trespidi" userId="fcf5a3d0aaa41ee2" providerId="LiveId" clId="{7614391D-DE7E-4F76-8922-D2DB3F3D93D6}" dt="2025-08-11T17:05:52.279" v="288" actId="1076"/>
          <ac:spMkLst>
            <pc:docMk/>
            <pc:sldMk cId="1940470235" sldId="283"/>
            <ac:spMk id="15" creationId="{DF79224C-DF2C-DFE9-E773-67FADBB77B9A}"/>
          </ac:spMkLst>
        </pc:spChg>
        <pc:spChg chg="mod">
          <ac:chgData name="Francesca Trespidi" userId="fcf5a3d0aaa41ee2" providerId="LiveId" clId="{7614391D-DE7E-4F76-8922-D2DB3F3D93D6}" dt="2025-08-12T09:31:22.384" v="421" actId="1076"/>
          <ac:spMkLst>
            <pc:docMk/>
            <pc:sldMk cId="1940470235" sldId="283"/>
            <ac:spMk id="18" creationId="{C0C775D5-FCF6-559B-D197-069A9296394B}"/>
          </ac:spMkLst>
        </pc:spChg>
        <pc:spChg chg="del">
          <ac:chgData name="Francesca Trespidi" userId="fcf5a3d0aaa41ee2" providerId="LiveId" clId="{7614391D-DE7E-4F76-8922-D2DB3F3D93D6}" dt="2025-08-11T17:05:15.019" v="275" actId="478"/>
          <ac:spMkLst>
            <pc:docMk/>
            <pc:sldMk cId="1940470235" sldId="283"/>
            <ac:spMk id="20" creationId="{A11950A8-0354-48F8-ACC2-216CAC9FD6C4}"/>
          </ac:spMkLst>
        </pc:spChg>
        <pc:spChg chg="del">
          <ac:chgData name="Francesca Trespidi" userId="fcf5a3d0aaa41ee2" providerId="LiveId" clId="{7614391D-DE7E-4F76-8922-D2DB3F3D93D6}" dt="2025-08-11T17:05:18.275" v="277" actId="478"/>
          <ac:spMkLst>
            <pc:docMk/>
            <pc:sldMk cId="1940470235" sldId="283"/>
            <ac:spMk id="22" creationId="{2EF7DBED-BAD7-64E7-389F-847738303232}"/>
          </ac:spMkLst>
        </pc:spChg>
        <pc:spChg chg="del">
          <ac:chgData name="Francesca Trespidi" userId="fcf5a3d0aaa41ee2" providerId="LiveId" clId="{7614391D-DE7E-4F76-8922-D2DB3F3D93D6}" dt="2025-08-11T17:05:15.019" v="275" actId="478"/>
          <ac:spMkLst>
            <pc:docMk/>
            <pc:sldMk cId="1940470235" sldId="283"/>
            <ac:spMk id="24" creationId="{D9D48C66-7284-0433-29D2-D65002DDBDBB}"/>
          </ac:spMkLst>
        </pc:spChg>
        <pc:spChg chg="add mod topLvl">
          <ac:chgData name="Francesca Trespidi" userId="fcf5a3d0aaa41ee2" providerId="LiveId" clId="{7614391D-DE7E-4F76-8922-D2DB3F3D93D6}" dt="2025-08-12T09:31:00.020" v="415" actId="165"/>
          <ac:spMkLst>
            <pc:docMk/>
            <pc:sldMk cId="1940470235" sldId="283"/>
            <ac:spMk id="26" creationId="{3FB9AE21-726E-DCAD-A7C4-461415A33578}"/>
          </ac:spMkLst>
        </pc:spChg>
        <pc:spChg chg="add del mod">
          <ac:chgData name="Francesca Trespidi" userId="fcf5a3d0aaa41ee2" providerId="LiveId" clId="{7614391D-DE7E-4F76-8922-D2DB3F3D93D6}" dt="2025-08-12T09:29:33.730" v="402" actId="478"/>
          <ac:spMkLst>
            <pc:docMk/>
            <pc:sldMk cId="1940470235" sldId="283"/>
            <ac:spMk id="28" creationId="{45839F49-63F7-48E2-95A5-0F0142373C43}"/>
          </ac:spMkLst>
        </pc:spChg>
        <pc:spChg chg="add del mod">
          <ac:chgData name="Francesca Trespidi" userId="fcf5a3d0aaa41ee2" providerId="LiveId" clId="{7614391D-DE7E-4F76-8922-D2DB3F3D93D6}" dt="2025-08-12T09:30:42.485" v="411" actId="478"/>
          <ac:spMkLst>
            <pc:docMk/>
            <pc:sldMk cId="1940470235" sldId="283"/>
            <ac:spMk id="30" creationId="{BAD5960D-AAE5-E177-EB5F-2E9F7D8C9999}"/>
          </ac:spMkLst>
        </pc:spChg>
        <pc:spChg chg="add mod topLvl">
          <ac:chgData name="Francesca Trespidi" userId="fcf5a3d0aaa41ee2" providerId="LiveId" clId="{7614391D-DE7E-4F76-8922-D2DB3F3D93D6}" dt="2025-08-12T09:31:18.131" v="419" actId="1076"/>
          <ac:spMkLst>
            <pc:docMk/>
            <pc:sldMk cId="1940470235" sldId="283"/>
            <ac:spMk id="32" creationId="{B46B5C3E-08F9-0342-BE7A-4ADE5AC35985}"/>
          </ac:spMkLst>
        </pc:spChg>
        <pc:grpChg chg="add del mod ord">
          <ac:chgData name="Francesca Trespidi" userId="fcf5a3d0aaa41ee2" providerId="LiveId" clId="{7614391D-DE7E-4F76-8922-D2DB3F3D93D6}" dt="2025-08-12T09:31:00.020" v="415" actId="165"/>
          <ac:grpSpMkLst>
            <pc:docMk/>
            <pc:sldMk cId="1940470235" sldId="283"/>
            <ac:grpSpMk id="33" creationId="{F3D644A3-7ABA-CD31-26E6-EEC70DB1C6DF}"/>
          </ac:grpSpMkLst>
        </pc:grpChg>
        <pc:picChg chg="del">
          <ac:chgData name="Francesca Trespidi" userId="fcf5a3d0aaa41ee2" providerId="LiveId" clId="{7614391D-DE7E-4F76-8922-D2DB3F3D93D6}" dt="2025-08-11T17:05:18.275" v="277" actId="478"/>
          <ac:picMkLst>
            <pc:docMk/>
            <pc:sldMk cId="1940470235" sldId="283"/>
            <ac:picMk id="3" creationId="{AE903175-D752-FFA5-72EF-DA5E97B3C781}"/>
          </ac:picMkLst>
        </pc:picChg>
        <pc:picChg chg="add mod topLvl">
          <ac:chgData name="Francesca Trespidi" userId="fcf5a3d0aaa41ee2" providerId="LiveId" clId="{7614391D-DE7E-4F76-8922-D2DB3F3D93D6}" dt="2025-08-12T09:31:00.020" v="415" actId="165"/>
          <ac:picMkLst>
            <pc:docMk/>
            <pc:sldMk cId="1940470235" sldId="283"/>
            <ac:picMk id="4" creationId="{A23EEE13-21E9-C7DE-1A16-8A46E24F2911}"/>
          </ac:picMkLst>
        </pc:picChg>
        <pc:picChg chg="add mod topLvl">
          <ac:chgData name="Francesca Trespidi" userId="fcf5a3d0aaa41ee2" providerId="LiveId" clId="{7614391D-DE7E-4F76-8922-D2DB3F3D93D6}" dt="2025-08-12T09:31:00.020" v="415" actId="165"/>
          <ac:picMkLst>
            <pc:docMk/>
            <pc:sldMk cId="1940470235" sldId="283"/>
            <ac:picMk id="5" creationId="{03E4AC6D-9A29-7EBE-9A19-8AB497FC9FC9}"/>
          </ac:picMkLst>
        </pc:picChg>
        <pc:picChg chg="add mod topLvl">
          <ac:chgData name="Francesca Trespidi" userId="fcf5a3d0aaa41ee2" providerId="LiveId" clId="{7614391D-DE7E-4F76-8922-D2DB3F3D93D6}" dt="2025-08-12T09:31:00.020" v="415" actId="165"/>
          <ac:picMkLst>
            <pc:docMk/>
            <pc:sldMk cId="1940470235" sldId="283"/>
            <ac:picMk id="6" creationId="{D0761C37-4850-DF02-5297-FF69BB315E92}"/>
          </ac:picMkLst>
        </pc:picChg>
        <pc:picChg chg="add mod topLvl">
          <ac:chgData name="Francesca Trespidi" userId="fcf5a3d0aaa41ee2" providerId="LiveId" clId="{7614391D-DE7E-4F76-8922-D2DB3F3D93D6}" dt="2025-08-12T09:31:00.020" v="415" actId="165"/>
          <ac:picMkLst>
            <pc:docMk/>
            <pc:sldMk cId="1940470235" sldId="283"/>
            <ac:picMk id="7" creationId="{680FC3BB-E57E-D37A-5C39-960739372D61}"/>
          </ac:picMkLst>
        </pc:picChg>
        <pc:picChg chg="del">
          <ac:chgData name="Francesca Trespidi" userId="fcf5a3d0aaa41ee2" providerId="LiveId" clId="{7614391D-DE7E-4F76-8922-D2DB3F3D93D6}" dt="2025-08-11T17:05:15.019" v="275" actId="478"/>
          <ac:picMkLst>
            <pc:docMk/>
            <pc:sldMk cId="1940470235" sldId="283"/>
            <ac:picMk id="11" creationId="{376C336A-3E34-7C51-1C6A-7CF59AC5D259}"/>
          </ac:picMkLst>
        </pc:picChg>
        <pc:picChg chg="del">
          <ac:chgData name="Francesca Trespidi" userId="fcf5a3d0aaa41ee2" providerId="LiveId" clId="{7614391D-DE7E-4F76-8922-D2DB3F3D93D6}" dt="2025-08-11T17:05:15.019" v="275" actId="478"/>
          <ac:picMkLst>
            <pc:docMk/>
            <pc:sldMk cId="1940470235" sldId="283"/>
            <ac:picMk id="12" creationId="{84BA4C8D-F90A-2F53-6305-FBAFF13B1E0F}"/>
          </ac:picMkLst>
        </pc:picChg>
        <pc:picChg chg="del">
          <ac:chgData name="Francesca Trespidi" userId="fcf5a3d0aaa41ee2" providerId="LiveId" clId="{7614391D-DE7E-4F76-8922-D2DB3F3D93D6}" dt="2025-08-11T17:05:19.391" v="279" actId="478"/>
          <ac:picMkLst>
            <pc:docMk/>
            <pc:sldMk cId="1940470235" sldId="283"/>
            <ac:picMk id="16" creationId="{5C83F822-69F9-16A6-A504-216A76133C96}"/>
          </ac:picMkLst>
        </pc:picChg>
        <pc:picChg chg="del">
          <ac:chgData name="Francesca Trespidi" userId="fcf5a3d0aaa41ee2" providerId="LiveId" clId="{7614391D-DE7E-4F76-8922-D2DB3F3D93D6}" dt="2025-08-11T17:05:15.442" v="276" actId="478"/>
          <ac:picMkLst>
            <pc:docMk/>
            <pc:sldMk cId="1940470235" sldId="283"/>
            <ac:picMk id="17" creationId="{671D4186-BCA9-579E-1562-287788425F26}"/>
          </ac:picMkLst>
        </pc:picChg>
        <pc:picChg chg="del">
          <ac:chgData name="Francesca Trespidi" userId="fcf5a3d0aaa41ee2" providerId="LiveId" clId="{7614391D-DE7E-4F76-8922-D2DB3F3D93D6}" dt="2025-08-11T17:05:19.028" v="278" actId="478"/>
          <ac:picMkLst>
            <pc:docMk/>
            <pc:sldMk cId="1940470235" sldId="283"/>
            <ac:picMk id="19" creationId="{5F2504A0-CCEA-311E-C34F-EE30E767366E}"/>
          </ac:picMkLst>
        </pc:picChg>
        <pc:cxnChg chg="mod topLvl">
          <ac:chgData name="Francesca Trespidi" userId="fcf5a3d0aaa41ee2" providerId="LiveId" clId="{7614391D-DE7E-4F76-8922-D2DB3F3D93D6}" dt="2025-08-12T09:31:00.020" v="415" actId="165"/>
          <ac:cxnSpMkLst>
            <pc:docMk/>
            <pc:sldMk cId="1940470235" sldId="283"/>
            <ac:cxnSpMk id="8" creationId="{1AD60592-EA5E-5526-FF6F-11322773D0BA}"/>
          </ac:cxnSpMkLst>
        </pc:cxnChg>
        <pc:cxnChg chg="del">
          <ac:chgData name="Francesca Trespidi" userId="fcf5a3d0aaa41ee2" providerId="LiveId" clId="{7614391D-DE7E-4F76-8922-D2DB3F3D93D6}" dt="2025-08-11T17:05:18.275" v="277" actId="478"/>
          <ac:cxnSpMkLst>
            <pc:docMk/>
            <pc:sldMk cId="1940470235" sldId="283"/>
            <ac:cxnSpMk id="10" creationId="{3D657645-F911-ADE3-F142-5F72DCBDBBD8}"/>
          </ac:cxnSpMkLst>
        </pc:cxnChg>
        <pc:cxnChg chg="add mod">
          <ac:chgData name="Francesca Trespidi" userId="fcf5a3d0aaa41ee2" providerId="LiveId" clId="{7614391D-DE7E-4F76-8922-D2DB3F3D93D6}" dt="2025-08-12T09:31:13.424" v="418" actId="14100"/>
          <ac:cxnSpMkLst>
            <pc:docMk/>
            <pc:sldMk cId="1940470235" sldId="283"/>
            <ac:cxnSpMk id="16" creationId="{0CE734CE-3EE0-279A-64AD-25D13022427A}"/>
          </ac:cxnSpMkLst>
        </pc:cxnChg>
        <pc:cxnChg chg="del">
          <ac:chgData name="Francesca Trespidi" userId="fcf5a3d0aaa41ee2" providerId="LiveId" clId="{7614391D-DE7E-4F76-8922-D2DB3F3D93D6}" dt="2025-08-11T17:05:15.019" v="275" actId="478"/>
          <ac:cxnSpMkLst>
            <pc:docMk/>
            <pc:sldMk cId="1940470235" sldId="283"/>
            <ac:cxnSpMk id="21" creationId="{0CFC23D9-5BCA-BDA6-212D-A8391507523F}"/>
          </ac:cxnSpMkLst>
        </pc:cxnChg>
        <pc:cxnChg chg="del">
          <ac:chgData name="Francesca Trespidi" userId="fcf5a3d0aaa41ee2" providerId="LiveId" clId="{7614391D-DE7E-4F76-8922-D2DB3F3D93D6}" dt="2025-08-11T17:05:18.275" v="277" actId="478"/>
          <ac:cxnSpMkLst>
            <pc:docMk/>
            <pc:sldMk cId="1940470235" sldId="283"/>
            <ac:cxnSpMk id="23" creationId="{CAB7889B-9CBB-2626-77CD-7EFA44AE7600}"/>
          </ac:cxnSpMkLst>
        </pc:cxnChg>
        <pc:cxnChg chg="del">
          <ac:chgData name="Francesca Trespidi" userId="fcf5a3d0aaa41ee2" providerId="LiveId" clId="{7614391D-DE7E-4F76-8922-D2DB3F3D93D6}" dt="2025-08-11T17:05:15.019" v="275" actId="478"/>
          <ac:cxnSpMkLst>
            <pc:docMk/>
            <pc:sldMk cId="1940470235" sldId="283"/>
            <ac:cxnSpMk id="25" creationId="{2836D91E-C8BD-9652-8669-0C61E7CDCF0B}"/>
          </ac:cxnSpMkLst>
        </pc:cxnChg>
        <pc:cxnChg chg="add del mod">
          <ac:chgData name="Francesca Trespidi" userId="fcf5a3d0aaa41ee2" providerId="LiveId" clId="{7614391D-DE7E-4F76-8922-D2DB3F3D93D6}" dt="2025-08-12T09:29:30.101" v="401" actId="478"/>
          <ac:cxnSpMkLst>
            <pc:docMk/>
            <pc:sldMk cId="1940470235" sldId="283"/>
            <ac:cxnSpMk id="27" creationId="{3A0EEB72-EEB1-D81A-9E95-34D513E29572}"/>
          </ac:cxnSpMkLst>
        </pc:cxnChg>
        <pc:cxnChg chg="del">
          <ac:chgData name="Francesca Trespidi" userId="fcf5a3d0aaa41ee2" providerId="LiveId" clId="{7614391D-DE7E-4F76-8922-D2DB3F3D93D6}" dt="2025-08-12T09:30:39.680" v="410" actId="478"/>
          <ac:cxnSpMkLst>
            <pc:docMk/>
            <pc:sldMk cId="1940470235" sldId="283"/>
            <ac:cxnSpMk id="29" creationId="{D6D2F730-CCD3-5B41-09ED-DA61954A8697}"/>
          </ac:cxnSpMkLst>
        </pc:cxnChg>
        <pc:cxnChg chg="add del mod">
          <ac:chgData name="Francesca Trespidi" userId="fcf5a3d0aaa41ee2" providerId="LiveId" clId="{7614391D-DE7E-4F76-8922-D2DB3F3D93D6}" dt="2025-08-12T09:30:47.415" v="412" actId="478"/>
          <ac:cxnSpMkLst>
            <pc:docMk/>
            <pc:sldMk cId="1940470235" sldId="283"/>
            <ac:cxnSpMk id="31" creationId="{D4D9BBD1-A267-B4D5-237E-B33261B800B4}"/>
          </ac:cxnSpMkLst>
        </pc:cxnChg>
      </pc:sldChg>
      <pc:sldChg chg="addSp delSp modSp add del mod ord">
        <pc:chgData name="Francesca Trespidi" userId="fcf5a3d0aaa41ee2" providerId="LiveId" clId="{7614391D-DE7E-4F76-8922-D2DB3F3D93D6}" dt="2025-08-12T09:43:58.389" v="464" actId="1035"/>
        <pc:sldMkLst>
          <pc:docMk/>
          <pc:sldMk cId="2574357676" sldId="284"/>
        </pc:sldMkLst>
        <pc:spChg chg="add mod">
          <ac:chgData name="Francesca Trespidi" userId="fcf5a3d0aaa41ee2" providerId="LiveId" clId="{7614391D-DE7E-4F76-8922-D2DB3F3D93D6}" dt="2025-08-11T17:30:49.527" v="354" actId="1076"/>
          <ac:spMkLst>
            <pc:docMk/>
            <pc:sldMk cId="2574357676" sldId="284"/>
            <ac:spMk id="4" creationId="{C482A662-6202-5D35-67E4-AD1898D90989}"/>
          </ac:spMkLst>
        </pc:spChg>
        <pc:spChg chg="del">
          <ac:chgData name="Francesca Trespidi" userId="fcf5a3d0aaa41ee2" providerId="LiveId" clId="{7614391D-DE7E-4F76-8922-D2DB3F3D93D6}" dt="2025-08-11T17:30:21.881" v="348" actId="478"/>
          <ac:spMkLst>
            <pc:docMk/>
            <pc:sldMk cId="2574357676" sldId="284"/>
            <ac:spMk id="9" creationId="{202CACF7-94AB-59C5-8FDF-299D51B5A56C}"/>
          </ac:spMkLst>
        </pc:spChg>
        <pc:spChg chg="add mod">
          <ac:chgData name="Francesca Trespidi" userId="fcf5a3d0aaa41ee2" providerId="LiveId" clId="{7614391D-DE7E-4F76-8922-D2DB3F3D93D6}" dt="2025-08-11T17:30:49.527" v="354" actId="1076"/>
          <ac:spMkLst>
            <pc:docMk/>
            <pc:sldMk cId="2574357676" sldId="284"/>
            <ac:spMk id="12" creationId="{F159CB43-C261-EAEF-5460-420EF97797A6}"/>
          </ac:spMkLst>
        </pc:spChg>
        <pc:spChg chg="add mod">
          <ac:chgData name="Francesca Trespidi" userId="fcf5a3d0aaa41ee2" providerId="LiveId" clId="{7614391D-DE7E-4F76-8922-D2DB3F3D93D6}" dt="2025-08-11T17:30:39.421" v="353" actId="1076"/>
          <ac:spMkLst>
            <pc:docMk/>
            <pc:sldMk cId="2574357676" sldId="284"/>
            <ac:spMk id="17" creationId="{674FB9A4-1E11-4B4D-6600-11755AFD9257}"/>
          </ac:spMkLst>
        </pc:spChg>
        <pc:spChg chg="mod">
          <ac:chgData name="Francesca Trespidi" userId="fcf5a3d0aaa41ee2" providerId="LiveId" clId="{7614391D-DE7E-4F76-8922-D2DB3F3D93D6}" dt="2025-08-12T08:51:41.790" v="364" actId="20577"/>
          <ac:spMkLst>
            <pc:docMk/>
            <pc:sldMk cId="2574357676" sldId="284"/>
            <ac:spMk id="18" creationId="{AA1951C3-00FB-23F9-AFBD-C51DFAC0B3AA}"/>
          </ac:spMkLst>
        </pc:spChg>
        <pc:spChg chg="del">
          <ac:chgData name="Francesca Trespidi" userId="fcf5a3d0aaa41ee2" providerId="LiveId" clId="{7614391D-DE7E-4F76-8922-D2DB3F3D93D6}" dt="2025-08-11T17:30:26.225" v="350" actId="478"/>
          <ac:spMkLst>
            <pc:docMk/>
            <pc:sldMk cId="2574357676" sldId="284"/>
            <ac:spMk id="20" creationId="{14C5D95E-F12D-F6EF-C21D-9C1AFB7B51C0}"/>
          </ac:spMkLst>
        </pc:spChg>
        <pc:spChg chg="del">
          <ac:chgData name="Francesca Trespidi" userId="fcf5a3d0aaa41ee2" providerId="LiveId" clId="{7614391D-DE7E-4F76-8922-D2DB3F3D93D6}" dt="2025-08-11T17:30:21.881" v="348" actId="478"/>
          <ac:spMkLst>
            <pc:docMk/>
            <pc:sldMk cId="2574357676" sldId="284"/>
            <ac:spMk id="22" creationId="{A682006D-3CFA-4676-C2B3-0FE8B0DDA46F}"/>
          </ac:spMkLst>
        </pc:spChg>
        <pc:spChg chg="del">
          <ac:chgData name="Francesca Trespidi" userId="fcf5a3d0aaa41ee2" providerId="LiveId" clId="{7614391D-DE7E-4F76-8922-D2DB3F3D93D6}" dt="2025-08-11T17:30:26.225" v="350" actId="478"/>
          <ac:spMkLst>
            <pc:docMk/>
            <pc:sldMk cId="2574357676" sldId="284"/>
            <ac:spMk id="24" creationId="{384EDCCC-2A21-FB7E-72AD-F44058CADF6C}"/>
          </ac:spMkLst>
        </pc:spChg>
        <pc:spChg chg="add mod">
          <ac:chgData name="Francesca Trespidi" userId="fcf5a3d0aaa41ee2" providerId="LiveId" clId="{7614391D-DE7E-4F76-8922-D2DB3F3D93D6}" dt="2025-08-11T17:30:39.421" v="353" actId="1076"/>
          <ac:spMkLst>
            <pc:docMk/>
            <pc:sldMk cId="2574357676" sldId="284"/>
            <ac:spMk id="26" creationId="{1237DABA-D668-D9E4-A681-0449176E9745}"/>
          </ac:spMkLst>
        </pc:spChg>
        <pc:picChg chg="del">
          <ac:chgData name="Francesca Trespidi" userId="fcf5a3d0aaa41ee2" providerId="LiveId" clId="{7614391D-DE7E-4F76-8922-D2DB3F3D93D6}" dt="2025-08-12T09:40:56.785" v="425" actId="478"/>
          <ac:picMkLst>
            <pc:docMk/>
            <pc:sldMk cId="2574357676" sldId="284"/>
            <ac:picMk id="7" creationId="{58EA9A8E-A228-D37E-36D1-234890530DCE}"/>
          </ac:picMkLst>
        </pc:picChg>
        <pc:picChg chg="del">
          <ac:chgData name="Francesca Trespidi" userId="fcf5a3d0aaa41ee2" providerId="LiveId" clId="{7614391D-DE7E-4F76-8922-D2DB3F3D93D6}" dt="2025-08-12T09:40:57.802" v="426" actId="478"/>
          <ac:picMkLst>
            <pc:docMk/>
            <pc:sldMk cId="2574357676" sldId="284"/>
            <ac:picMk id="8" creationId="{0B548745-3FD5-C823-26F5-4F266EF7D03E}"/>
          </ac:picMkLst>
        </pc:picChg>
        <pc:picChg chg="add mod modCrop">
          <ac:chgData name="Francesca Trespidi" userId="fcf5a3d0aaa41ee2" providerId="LiveId" clId="{7614391D-DE7E-4F76-8922-D2DB3F3D93D6}" dt="2025-08-12T09:43:58.389" v="464" actId="1035"/>
          <ac:picMkLst>
            <pc:docMk/>
            <pc:sldMk cId="2574357676" sldId="284"/>
            <ac:picMk id="10" creationId="{B97B0125-4B87-2D88-6185-22D2F941DA3E}"/>
          </ac:picMkLst>
        </pc:picChg>
        <pc:picChg chg="add mod modCrop">
          <ac:chgData name="Francesca Trespidi" userId="fcf5a3d0aaa41ee2" providerId="LiveId" clId="{7614391D-DE7E-4F76-8922-D2DB3F3D93D6}" dt="2025-08-12T09:43:58.389" v="464" actId="1035"/>
          <ac:picMkLst>
            <pc:docMk/>
            <pc:sldMk cId="2574357676" sldId="284"/>
            <ac:picMk id="21" creationId="{3623B83D-CEDA-1644-4F2A-17793A7321B4}"/>
          </ac:picMkLst>
        </pc:picChg>
        <pc:picChg chg="add mod modCrop">
          <ac:chgData name="Francesca Trespidi" userId="fcf5a3d0aaa41ee2" providerId="LiveId" clId="{7614391D-DE7E-4F76-8922-D2DB3F3D93D6}" dt="2025-08-12T09:43:58.389" v="464" actId="1035"/>
          <ac:picMkLst>
            <pc:docMk/>
            <pc:sldMk cId="2574357676" sldId="284"/>
            <ac:picMk id="22" creationId="{1696EF3F-1BBA-26C7-EF7F-9E1D70408091}"/>
          </ac:picMkLst>
        </pc:picChg>
        <pc:cxnChg chg="add mod">
          <ac:chgData name="Francesca Trespidi" userId="fcf5a3d0aaa41ee2" providerId="LiveId" clId="{7614391D-DE7E-4F76-8922-D2DB3F3D93D6}" dt="2025-08-11T17:30:49.527" v="354" actId="1076"/>
          <ac:cxnSpMkLst>
            <pc:docMk/>
            <pc:sldMk cId="2574357676" sldId="284"/>
            <ac:cxnSpMk id="3" creationId="{F48E448B-C276-0A9C-4BEC-19C9F713D4AF}"/>
          </ac:cxnSpMkLst>
        </pc:cxnChg>
        <pc:cxnChg chg="del">
          <ac:chgData name="Francesca Trespidi" userId="fcf5a3d0aaa41ee2" providerId="LiveId" clId="{7614391D-DE7E-4F76-8922-D2DB3F3D93D6}" dt="2025-08-11T17:30:21.881" v="348" actId="478"/>
          <ac:cxnSpMkLst>
            <pc:docMk/>
            <pc:sldMk cId="2574357676" sldId="284"/>
            <ac:cxnSpMk id="10" creationId="{AD646932-D8DC-B2F0-CD0F-990427E1E548}"/>
          </ac:cxnSpMkLst>
        </pc:cxnChg>
        <pc:cxnChg chg="add mod">
          <ac:chgData name="Francesca Trespidi" userId="fcf5a3d0aaa41ee2" providerId="LiveId" clId="{7614391D-DE7E-4F76-8922-D2DB3F3D93D6}" dt="2025-08-11T17:30:49.527" v="354" actId="1076"/>
          <ac:cxnSpMkLst>
            <pc:docMk/>
            <pc:sldMk cId="2574357676" sldId="284"/>
            <ac:cxnSpMk id="11" creationId="{196193DB-8D57-EA25-F927-FED03AC551AA}"/>
          </ac:cxnSpMkLst>
        </pc:cxnChg>
        <pc:cxnChg chg="add mod">
          <ac:chgData name="Francesca Trespidi" userId="fcf5a3d0aaa41ee2" providerId="LiveId" clId="{7614391D-DE7E-4F76-8922-D2DB3F3D93D6}" dt="2025-08-11T17:30:39.421" v="353" actId="1076"/>
          <ac:cxnSpMkLst>
            <pc:docMk/>
            <pc:sldMk cId="2574357676" sldId="284"/>
            <ac:cxnSpMk id="16" creationId="{2A2BC66A-05FD-4B92-129F-67DD68A51645}"/>
          </ac:cxnSpMkLst>
        </pc:cxnChg>
        <pc:cxnChg chg="add mod">
          <ac:chgData name="Francesca Trespidi" userId="fcf5a3d0aaa41ee2" providerId="LiveId" clId="{7614391D-DE7E-4F76-8922-D2DB3F3D93D6}" dt="2025-08-11T17:30:39.421" v="353" actId="1076"/>
          <ac:cxnSpMkLst>
            <pc:docMk/>
            <pc:sldMk cId="2574357676" sldId="284"/>
            <ac:cxnSpMk id="19" creationId="{9BBBDD2F-F137-C54F-D1EB-3E3C6B9DDA2B}"/>
          </ac:cxnSpMkLst>
        </pc:cxnChg>
        <pc:cxnChg chg="del">
          <ac:chgData name="Francesca Trespidi" userId="fcf5a3d0aaa41ee2" providerId="LiveId" clId="{7614391D-DE7E-4F76-8922-D2DB3F3D93D6}" dt="2025-08-11T17:30:26.225" v="350" actId="478"/>
          <ac:cxnSpMkLst>
            <pc:docMk/>
            <pc:sldMk cId="2574357676" sldId="284"/>
            <ac:cxnSpMk id="21" creationId="{A62AE0A6-03F2-3F84-B198-5C90FB035845}"/>
          </ac:cxnSpMkLst>
        </pc:cxnChg>
        <pc:cxnChg chg="del">
          <ac:chgData name="Francesca Trespidi" userId="fcf5a3d0aaa41ee2" providerId="LiveId" clId="{7614391D-DE7E-4F76-8922-D2DB3F3D93D6}" dt="2025-08-11T17:30:21.881" v="348" actId="478"/>
          <ac:cxnSpMkLst>
            <pc:docMk/>
            <pc:sldMk cId="2574357676" sldId="284"/>
            <ac:cxnSpMk id="23" creationId="{A52D1743-344D-04FD-00E1-1A870A054D7D}"/>
          </ac:cxnSpMkLst>
        </pc:cxnChg>
        <pc:cxnChg chg="del">
          <ac:chgData name="Francesca Trespidi" userId="fcf5a3d0aaa41ee2" providerId="LiveId" clId="{7614391D-DE7E-4F76-8922-D2DB3F3D93D6}" dt="2025-08-11T17:30:26.225" v="350" actId="478"/>
          <ac:cxnSpMkLst>
            <pc:docMk/>
            <pc:sldMk cId="2574357676" sldId="284"/>
            <ac:cxnSpMk id="25" creationId="{97F76076-FEE0-E19E-E29B-2782FA175AB3}"/>
          </ac:cxnSpMkLst>
        </pc:cxnChg>
      </pc:sldChg>
      <pc:sldChg chg="addSp delSp modSp mod">
        <pc:chgData name="Francesca Trespidi" userId="fcf5a3d0aaa41ee2" providerId="LiveId" clId="{7614391D-DE7E-4F76-8922-D2DB3F3D93D6}" dt="2025-08-12T10:38:14.237" v="487" actId="14100"/>
        <pc:sldMkLst>
          <pc:docMk/>
          <pc:sldMk cId="1512124061" sldId="285"/>
        </pc:sldMkLst>
        <pc:spChg chg="mod">
          <ac:chgData name="Francesca Trespidi" userId="fcf5a3d0aaa41ee2" providerId="LiveId" clId="{7614391D-DE7E-4F76-8922-D2DB3F3D93D6}" dt="2025-08-12T08:51:49.287" v="370" actId="20577"/>
          <ac:spMkLst>
            <pc:docMk/>
            <pc:sldMk cId="1512124061" sldId="285"/>
            <ac:spMk id="3" creationId="{D831CC9B-E1BD-4A49-CBE3-0FB5E68D9341}"/>
          </ac:spMkLst>
        </pc:spChg>
        <pc:spChg chg="del">
          <ac:chgData name="Francesca Trespidi" userId="fcf5a3d0aaa41ee2" providerId="LiveId" clId="{7614391D-DE7E-4F76-8922-D2DB3F3D93D6}" dt="2025-08-11T17:07:15.378" v="297" actId="478"/>
          <ac:spMkLst>
            <pc:docMk/>
            <pc:sldMk cId="1512124061" sldId="285"/>
            <ac:spMk id="4" creationId="{AE7931FE-AEC0-945F-7838-C8C9119477EB}"/>
          </ac:spMkLst>
        </pc:spChg>
        <pc:spChg chg="del">
          <ac:chgData name="Francesca Trespidi" userId="fcf5a3d0aaa41ee2" providerId="LiveId" clId="{7614391D-DE7E-4F76-8922-D2DB3F3D93D6}" dt="2025-08-11T17:07:18.422" v="299" actId="478"/>
          <ac:spMkLst>
            <pc:docMk/>
            <pc:sldMk cId="1512124061" sldId="285"/>
            <ac:spMk id="6" creationId="{B5948846-D9C9-5DCE-521B-1E15203A15C3}"/>
          </ac:spMkLst>
        </pc:spChg>
        <pc:spChg chg="add mod">
          <ac:chgData name="Francesca Trespidi" userId="fcf5a3d0aaa41ee2" providerId="LiveId" clId="{7614391D-DE7E-4F76-8922-D2DB3F3D93D6}" dt="2025-08-11T17:07:59.560" v="312" actId="208"/>
          <ac:spMkLst>
            <pc:docMk/>
            <pc:sldMk cId="1512124061" sldId="285"/>
            <ac:spMk id="12" creationId="{413F4AAA-61DD-6162-90C4-F87CF0A94AA7}"/>
          </ac:spMkLst>
        </pc:spChg>
        <pc:spChg chg="add mod">
          <ac:chgData name="Francesca Trespidi" userId="fcf5a3d0aaa41ee2" providerId="LiveId" clId="{7614391D-DE7E-4F76-8922-D2DB3F3D93D6}" dt="2025-08-11T17:08:04.785" v="313" actId="207"/>
          <ac:spMkLst>
            <pc:docMk/>
            <pc:sldMk cId="1512124061" sldId="285"/>
            <ac:spMk id="14" creationId="{F8E1892E-86EA-7AE3-3676-31840B74582E}"/>
          </ac:spMkLst>
        </pc:spChg>
        <pc:picChg chg="add mod">
          <ac:chgData name="Francesca Trespidi" userId="fcf5a3d0aaa41ee2" providerId="LiveId" clId="{7614391D-DE7E-4F76-8922-D2DB3F3D93D6}" dt="2025-08-12T10:33:39.902" v="485" actId="14100"/>
          <ac:picMkLst>
            <pc:docMk/>
            <pc:sldMk cId="1512124061" sldId="285"/>
            <ac:picMk id="4" creationId="{D2694D7D-E556-239D-7659-B3A3AB9C9D52}"/>
          </ac:picMkLst>
        </pc:picChg>
        <pc:picChg chg="add mod">
          <ac:chgData name="Francesca Trespidi" userId="fcf5a3d0aaa41ee2" providerId="LiveId" clId="{7614391D-DE7E-4F76-8922-D2DB3F3D93D6}" dt="2025-08-12T10:38:14.237" v="487" actId="14100"/>
          <ac:picMkLst>
            <pc:docMk/>
            <pc:sldMk cId="1512124061" sldId="285"/>
            <ac:picMk id="5" creationId="{283383C9-86C7-AB39-7377-788F02EB5F1B}"/>
          </ac:picMkLst>
        </pc:picChg>
        <pc:picChg chg="del">
          <ac:chgData name="Francesca Trespidi" userId="fcf5a3d0aaa41ee2" providerId="LiveId" clId="{7614391D-DE7E-4F76-8922-D2DB3F3D93D6}" dt="2025-08-12T09:09:34.684" v="386" actId="478"/>
          <ac:picMkLst>
            <pc:docMk/>
            <pc:sldMk cId="1512124061" sldId="285"/>
            <ac:picMk id="8" creationId="{55047926-6CFF-4997-7F17-2EAC121FDC03}"/>
          </ac:picMkLst>
        </pc:picChg>
        <pc:picChg chg="mod">
          <ac:chgData name="Francesca Trespidi" userId="fcf5a3d0aaa41ee2" providerId="LiveId" clId="{7614391D-DE7E-4F76-8922-D2DB3F3D93D6}" dt="2025-08-12T10:34:27.365" v="486" actId="1076"/>
          <ac:picMkLst>
            <pc:docMk/>
            <pc:sldMk cId="1512124061" sldId="285"/>
            <ac:picMk id="9" creationId="{E85E544A-CAB8-726A-8FA9-8CC8A18ED900}"/>
          </ac:picMkLst>
        </pc:picChg>
        <pc:picChg chg="del">
          <ac:chgData name="Francesca Trespidi" userId="fcf5a3d0aaa41ee2" providerId="LiveId" clId="{7614391D-DE7E-4F76-8922-D2DB3F3D93D6}" dt="2025-08-12T09:10:12.724" v="395" actId="478"/>
          <ac:picMkLst>
            <pc:docMk/>
            <pc:sldMk cId="1512124061" sldId="285"/>
            <ac:picMk id="10" creationId="{85C8128D-AA2F-C255-49C6-A8116636DC0A}"/>
          </ac:picMkLst>
        </pc:picChg>
        <pc:cxnChg chg="add mod">
          <ac:chgData name="Francesca Trespidi" userId="fcf5a3d0aaa41ee2" providerId="LiveId" clId="{7614391D-DE7E-4F76-8922-D2DB3F3D93D6}" dt="2025-08-11T17:08:11.806" v="314" actId="13822"/>
          <ac:cxnSpMkLst>
            <pc:docMk/>
            <pc:sldMk cId="1512124061" sldId="285"/>
            <ac:cxnSpMk id="2" creationId="{03ABAA56-B5AF-3C7A-3091-ADA957C74100}"/>
          </ac:cxnSpMkLst>
        </pc:cxnChg>
        <pc:cxnChg chg="del">
          <ac:chgData name="Francesca Trespidi" userId="fcf5a3d0aaa41ee2" providerId="LiveId" clId="{7614391D-DE7E-4F76-8922-D2DB3F3D93D6}" dt="2025-08-11T17:07:14.453" v="296" actId="478"/>
          <ac:cxnSpMkLst>
            <pc:docMk/>
            <pc:sldMk cId="1512124061" sldId="285"/>
            <ac:cxnSpMk id="5" creationId="{9577606C-B51F-FEE9-1B9B-348A173CFA50}"/>
          </ac:cxnSpMkLst>
        </pc:cxnChg>
        <pc:cxnChg chg="del">
          <ac:chgData name="Francesca Trespidi" userId="fcf5a3d0aaa41ee2" providerId="LiveId" clId="{7614391D-DE7E-4F76-8922-D2DB3F3D93D6}" dt="2025-08-11T17:07:17.038" v="298" actId="478"/>
          <ac:cxnSpMkLst>
            <pc:docMk/>
            <pc:sldMk cId="1512124061" sldId="285"/>
            <ac:cxnSpMk id="7" creationId="{18723F25-FC72-9DDC-0275-013AD59F78C7}"/>
          </ac:cxnSpMkLst>
        </pc:cxnChg>
        <pc:cxnChg chg="add mod">
          <ac:chgData name="Francesca Trespidi" userId="fcf5a3d0aaa41ee2" providerId="LiveId" clId="{7614391D-DE7E-4F76-8922-D2DB3F3D93D6}" dt="2025-08-11T17:08:13.457" v="315" actId="13822"/>
          <ac:cxnSpMkLst>
            <pc:docMk/>
            <pc:sldMk cId="1512124061" sldId="285"/>
            <ac:cxnSpMk id="13" creationId="{C885CF64-C334-AFED-37CF-4D72E88D01CA}"/>
          </ac:cxnSpMkLst>
        </pc:cxnChg>
      </pc:sldChg>
      <pc:sldChg chg="addSp delSp modSp add mod">
        <pc:chgData name="Francesca Trespidi" userId="fcf5a3d0aaa41ee2" providerId="LiveId" clId="{7614391D-DE7E-4F76-8922-D2DB3F3D93D6}" dt="2025-08-11T15:18:22.946" v="16" actId="14100"/>
        <pc:sldMkLst>
          <pc:docMk/>
          <pc:sldMk cId="2662882528" sldId="286"/>
        </pc:sldMkLst>
        <pc:picChg chg="add mod">
          <ac:chgData name="Francesca Trespidi" userId="fcf5a3d0aaa41ee2" providerId="LiveId" clId="{7614391D-DE7E-4F76-8922-D2DB3F3D93D6}" dt="2025-08-11T15:18:22.946" v="16" actId="14100"/>
          <ac:picMkLst>
            <pc:docMk/>
            <pc:sldMk cId="2662882528" sldId="286"/>
            <ac:picMk id="3" creationId="{58FAD5F6-52B8-A419-F470-CC2CCB6FB111}"/>
          </ac:picMkLst>
        </pc:picChg>
        <pc:picChg chg="del">
          <ac:chgData name="Francesca Trespidi" userId="fcf5a3d0aaa41ee2" providerId="LiveId" clId="{7614391D-DE7E-4F76-8922-D2DB3F3D93D6}" dt="2025-08-11T15:12:18.891" v="1" actId="478"/>
          <ac:picMkLst>
            <pc:docMk/>
            <pc:sldMk cId="2662882528" sldId="286"/>
            <ac:picMk id="17" creationId="{332DB408-1903-DA0A-6FD7-D85949A0224B}"/>
          </ac:picMkLst>
        </pc:picChg>
      </pc:sldChg>
      <pc:sldChg chg="add del">
        <pc:chgData name="Francesca Trespidi" userId="fcf5a3d0aaa41ee2" providerId="LiveId" clId="{7614391D-DE7E-4F76-8922-D2DB3F3D93D6}" dt="2025-08-11T17:29:30.626" v="343" actId="47"/>
        <pc:sldMkLst>
          <pc:docMk/>
          <pc:sldMk cId="796308112" sldId="287"/>
        </pc:sldMkLst>
      </pc:sldChg>
      <pc:sldChg chg="addSp delSp modSp add del mod">
        <pc:chgData name="Francesca Trespidi" userId="fcf5a3d0aaa41ee2" providerId="LiveId" clId="{7614391D-DE7E-4F76-8922-D2DB3F3D93D6}" dt="2025-08-11T15:18:31.869" v="17" actId="47"/>
        <pc:sldMkLst>
          <pc:docMk/>
          <pc:sldMk cId="844693945" sldId="287"/>
        </pc:sldMkLst>
        <pc:graphicFrameChg chg="add del mod">
          <ac:chgData name="Francesca Trespidi" userId="fcf5a3d0aaa41ee2" providerId="LiveId" clId="{7614391D-DE7E-4F76-8922-D2DB3F3D93D6}" dt="2025-08-11T15:17:39.897" v="4" actId="21"/>
          <ac:graphicFrameMkLst>
            <pc:docMk/>
            <pc:sldMk cId="844693945" sldId="287"/>
            <ac:graphicFrameMk id="2" creationId="{0B6174C6-387E-B504-F745-DAED20FB1C99}"/>
          </ac:graphicFrameMkLst>
        </pc:graphicFrameChg>
        <pc:picChg chg="add del mod">
          <ac:chgData name="Francesca Trespidi" userId="fcf5a3d0aaa41ee2" providerId="LiveId" clId="{7614391D-DE7E-4F76-8922-D2DB3F3D93D6}" dt="2025-08-11T15:18:08.225" v="8" actId="21"/>
          <ac:picMkLst>
            <pc:docMk/>
            <pc:sldMk cId="844693945" sldId="287"/>
            <ac:picMk id="3" creationId="{58FAD5F6-52B8-A419-F470-CC2CCB6FB111}"/>
          </ac:picMkLst>
        </pc:picChg>
      </pc:sldChg>
      <pc:sldChg chg="addSp delSp modSp add del mod">
        <pc:chgData name="Francesca Trespidi" userId="fcf5a3d0aaa41ee2" providerId="LiveId" clId="{7614391D-DE7E-4F76-8922-D2DB3F3D93D6}" dt="2025-08-12T09:10:32.466" v="399" actId="47"/>
        <pc:sldMkLst>
          <pc:docMk/>
          <pc:sldMk cId="1034919142" sldId="287"/>
        </pc:sldMkLst>
        <pc:graphicFrameChg chg="add del mod">
          <ac:chgData name="Francesca Trespidi" userId="fcf5a3d0aaa41ee2" providerId="LiveId" clId="{7614391D-DE7E-4F76-8922-D2DB3F3D93D6}" dt="2025-08-12T09:08:50.922" v="375" actId="21"/>
          <ac:graphicFrameMkLst>
            <pc:docMk/>
            <pc:sldMk cId="1034919142" sldId="287"/>
            <ac:graphicFrameMk id="2" creationId="{3824BD9B-8620-C379-65A1-01F0018B103B}"/>
          </ac:graphicFrameMkLst>
        </pc:graphicFrameChg>
        <pc:picChg chg="add mod modCrop">
          <ac:chgData name="Francesca Trespidi" userId="fcf5a3d0aaa41ee2" providerId="LiveId" clId="{7614391D-DE7E-4F76-8922-D2DB3F3D93D6}" dt="2025-08-12T09:08:57.694" v="377" actId="732"/>
          <ac:picMkLst>
            <pc:docMk/>
            <pc:sldMk cId="1034919142" sldId="287"/>
            <ac:picMk id="3" creationId="{C129E263-9989-1EFC-93CC-005933F3D98C}"/>
          </ac:picMkLst>
        </pc:picChg>
      </pc:sldChg>
      <pc:sldChg chg="addSp modSp new del mod">
        <pc:chgData name="Francesca Trespidi" userId="fcf5a3d0aaa41ee2" providerId="LiveId" clId="{7614391D-DE7E-4F76-8922-D2DB3F3D93D6}" dt="2025-08-11T17:06:01.312" v="289" actId="47"/>
        <pc:sldMkLst>
          <pc:docMk/>
          <pc:sldMk cId="1486627830" sldId="287"/>
        </pc:sldMkLst>
        <pc:spChg chg="add mod">
          <ac:chgData name="Francesca Trespidi" userId="fcf5a3d0aaa41ee2" providerId="LiveId" clId="{7614391D-DE7E-4F76-8922-D2DB3F3D93D6}" dt="2025-08-11T17:03:30.350" v="256"/>
          <ac:spMkLst>
            <pc:docMk/>
            <pc:sldMk cId="1486627830" sldId="287"/>
            <ac:spMk id="11" creationId="{011AB47B-85D4-AF5A-AE17-1AE5E348844B}"/>
          </ac:spMkLst>
        </pc:spChg>
        <pc:spChg chg="add mod">
          <ac:chgData name="Francesca Trespidi" userId="fcf5a3d0aaa41ee2" providerId="LiveId" clId="{7614391D-DE7E-4F76-8922-D2DB3F3D93D6}" dt="2025-08-11T17:03:30.350" v="256"/>
          <ac:spMkLst>
            <pc:docMk/>
            <pc:sldMk cId="1486627830" sldId="287"/>
            <ac:spMk id="13" creationId="{FC79A242-E648-9291-51CE-22CB16617F4F}"/>
          </ac:spMkLst>
        </pc:spChg>
        <pc:spChg chg="add mod">
          <ac:chgData name="Francesca Trespidi" userId="fcf5a3d0aaa41ee2" providerId="LiveId" clId="{7614391D-DE7E-4F76-8922-D2DB3F3D93D6}" dt="2025-08-11T17:04:34.315" v="269" actId="1076"/>
          <ac:spMkLst>
            <pc:docMk/>
            <pc:sldMk cId="1486627830" sldId="287"/>
            <ac:spMk id="16" creationId="{A2C5A8FA-6381-6C32-59BF-FA5799D05CA7}"/>
          </ac:spMkLst>
        </pc:spChg>
        <pc:spChg chg="add mod">
          <ac:chgData name="Francesca Trespidi" userId="fcf5a3d0aaa41ee2" providerId="LiveId" clId="{7614391D-DE7E-4F76-8922-D2DB3F3D93D6}" dt="2025-08-11T17:04:34.315" v="269" actId="1076"/>
          <ac:spMkLst>
            <pc:docMk/>
            <pc:sldMk cId="1486627830" sldId="287"/>
            <ac:spMk id="18" creationId="{876B3833-7086-B129-8DCB-70939153C9E9}"/>
          </ac:spMkLst>
        </pc:spChg>
        <pc:spChg chg="add mod">
          <ac:chgData name="Francesca Trespidi" userId="fcf5a3d0aaa41ee2" providerId="LiveId" clId="{7614391D-DE7E-4F76-8922-D2DB3F3D93D6}" dt="2025-08-11T17:04:55.793" v="274" actId="1076"/>
          <ac:spMkLst>
            <pc:docMk/>
            <pc:sldMk cId="1486627830" sldId="287"/>
            <ac:spMk id="23" creationId="{685DDAA4-6D65-9CD5-612B-E1383432FE7D}"/>
          </ac:spMkLst>
        </pc:spChg>
        <pc:spChg chg="add mod">
          <ac:chgData name="Francesca Trespidi" userId="fcf5a3d0aaa41ee2" providerId="LiveId" clId="{7614391D-DE7E-4F76-8922-D2DB3F3D93D6}" dt="2025-08-11T17:04:55.793" v="274" actId="1076"/>
          <ac:spMkLst>
            <pc:docMk/>
            <pc:sldMk cId="1486627830" sldId="287"/>
            <ac:spMk id="25" creationId="{8D04C87C-8566-C789-9AC0-D03682197AAD}"/>
          </ac:spMkLst>
        </pc:spChg>
        <pc:picChg chg="add mod">
          <ac:chgData name="Francesca Trespidi" userId="fcf5a3d0aaa41ee2" providerId="LiveId" clId="{7614391D-DE7E-4F76-8922-D2DB3F3D93D6}" dt="2025-08-11T17:03:53.392" v="259" actId="14100"/>
          <ac:picMkLst>
            <pc:docMk/>
            <pc:sldMk cId="1486627830" sldId="287"/>
            <ac:picMk id="3" creationId="{EF906FA9-2AAC-8E1D-68C2-2731B678CF87}"/>
          </ac:picMkLst>
        </pc:picChg>
        <pc:picChg chg="add mod">
          <ac:chgData name="Francesca Trespidi" userId="fcf5a3d0aaa41ee2" providerId="LiveId" clId="{7614391D-DE7E-4F76-8922-D2DB3F3D93D6}" dt="2025-08-11T17:04:27.574" v="267" actId="1076"/>
          <ac:picMkLst>
            <pc:docMk/>
            <pc:sldMk cId="1486627830" sldId="287"/>
            <ac:picMk id="5" creationId="{502B5482-4949-52F3-1AA8-0E34D64B74FE}"/>
          </ac:picMkLst>
        </pc:picChg>
        <pc:picChg chg="add mod">
          <ac:chgData name="Francesca Trespidi" userId="fcf5a3d0aaa41ee2" providerId="LiveId" clId="{7614391D-DE7E-4F76-8922-D2DB3F3D93D6}" dt="2025-08-11T17:03:59.320" v="261" actId="1076"/>
          <ac:picMkLst>
            <pc:docMk/>
            <pc:sldMk cId="1486627830" sldId="287"/>
            <ac:picMk id="7" creationId="{4FAEC7F7-FA28-DCD1-5F08-4D5F818B160D}"/>
          </ac:picMkLst>
        </pc:picChg>
        <pc:picChg chg="add mod">
          <ac:chgData name="Francesca Trespidi" userId="fcf5a3d0aaa41ee2" providerId="LiveId" clId="{7614391D-DE7E-4F76-8922-D2DB3F3D93D6}" dt="2025-08-11T17:04:27.574" v="267" actId="1076"/>
          <ac:picMkLst>
            <pc:docMk/>
            <pc:sldMk cId="1486627830" sldId="287"/>
            <ac:picMk id="9" creationId="{E081005C-86FD-04FE-7D95-664DDBDDF4DA}"/>
          </ac:picMkLst>
        </pc:picChg>
        <pc:cxnChg chg="add mod">
          <ac:chgData name="Francesca Trespidi" userId="fcf5a3d0aaa41ee2" providerId="LiveId" clId="{7614391D-DE7E-4F76-8922-D2DB3F3D93D6}" dt="2025-08-11T17:03:42.176" v="258" actId="14100"/>
          <ac:cxnSpMkLst>
            <pc:docMk/>
            <pc:sldMk cId="1486627830" sldId="287"/>
            <ac:cxnSpMk id="10" creationId="{E18FCC6D-2057-3A59-751E-374ADD5EFA18}"/>
          </ac:cxnSpMkLst>
        </pc:cxnChg>
        <pc:cxnChg chg="add mod">
          <ac:chgData name="Francesca Trespidi" userId="fcf5a3d0aaa41ee2" providerId="LiveId" clId="{7614391D-DE7E-4F76-8922-D2DB3F3D93D6}" dt="2025-08-11T17:03:30.350" v="256"/>
          <ac:cxnSpMkLst>
            <pc:docMk/>
            <pc:sldMk cId="1486627830" sldId="287"/>
            <ac:cxnSpMk id="12" creationId="{4461DFB3-3F2F-33E6-F2E4-3B127DE1EBF7}"/>
          </ac:cxnSpMkLst>
        </pc:cxnChg>
        <pc:cxnChg chg="add mod">
          <ac:chgData name="Francesca Trespidi" userId="fcf5a3d0aaa41ee2" providerId="LiveId" clId="{7614391D-DE7E-4F76-8922-D2DB3F3D93D6}" dt="2025-08-11T17:04:43.296" v="272" actId="14100"/>
          <ac:cxnSpMkLst>
            <pc:docMk/>
            <pc:sldMk cId="1486627830" sldId="287"/>
            <ac:cxnSpMk id="15" creationId="{2D97DEF4-A825-42E2-ED03-0412D9EBF935}"/>
          </ac:cxnSpMkLst>
        </pc:cxnChg>
        <pc:cxnChg chg="add mod">
          <ac:chgData name="Francesca Trespidi" userId="fcf5a3d0aaa41ee2" providerId="LiveId" clId="{7614391D-DE7E-4F76-8922-D2DB3F3D93D6}" dt="2025-08-11T17:04:38.680" v="270" actId="14100"/>
          <ac:cxnSpMkLst>
            <pc:docMk/>
            <pc:sldMk cId="1486627830" sldId="287"/>
            <ac:cxnSpMk id="17" creationId="{E12DAC91-985C-E200-1DC9-20320D6F6FA6}"/>
          </ac:cxnSpMkLst>
        </pc:cxnChg>
        <pc:cxnChg chg="add mod">
          <ac:chgData name="Francesca Trespidi" userId="fcf5a3d0aaa41ee2" providerId="LiveId" clId="{7614391D-DE7E-4F76-8922-D2DB3F3D93D6}" dt="2025-08-11T17:04:55.793" v="274" actId="1076"/>
          <ac:cxnSpMkLst>
            <pc:docMk/>
            <pc:sldMk cId="1486627830" sldId="287"/>
            <ac:cxnSpMk id="22" creationId="{06B7FA11-5EDC-1127-9EC9-72FCB58F6221}"/>
          </ac:cxnSpMkLst>
        </pc:cxnChg>
        <pc:cxnChg chg="add mod">
          <ac:chgData name="Francesca Trespidi" userId="fcf5a3d0aaa41ee2" providerId="LiveId" clId="{7614391D-DE7E-4F76-8922-D2DB3F3D93D6}" dt="2025-08-11T17:04:55.793" v="274" actId="1076"/>
          <ac:cxnSpMkLst>
            <pc:docMk/>
            <pc:sldMk cId="1486627830" sldId="287"/>
            <ac:cxnSpMk id="24" creationId="{E0D56519-75F2-23CB-FD17-9CBD5C555A7D}"/>
          </ac:cxnSpMkLst>
        </pc:cxnChg>
      </pc:sldChg>
      <pc:sldChg chg="addSp delSp modSp add del mod">
        <pc:chgData name="Francesca Trespidi" userId="fcf5a3d0aaa41ee2" providerId="LiveId" clId="{7614391D-DE7E-4F76-8922-D2DB3F3D93D6}" dt="2025-08-11T15:20:36.078" v="34" actId="47"/>
        <pc:sldMkLst>
          <pc:docMk/>
          <pc:sldMk cId="1704906247" sldId="287"/>
        </pc:sldMkLst>
        <pc:graphicFrameChg chg="add del mod">
          <ac:chgData name="Francesca Trespidi" userId="fcf5a3d0aaa41ee2" providerId="LiveId" clId="{7614391D-DE7E-4F76-8922-D2DB3F3D93D6}" dt="2025-08-11T15:19:42.550" v="20" actId="21"/>
          <ac:graphicFrameMkLst>
            <pc:docMk/>
            <pc:sldMk cId="1704906247" sldId="287"/>
            <ac:graphicFrameMk id="2" creationId="{B8BF2BFA-2A57-B17E-A7B3-033DF80C069E}"/>
          </ac:graphicFrameMkLst>
        </pc:graphicFrameChg>
        <pc:picChg chg="add del mod">
          <ac:chgData name="Francesca Trespidi" userId="fcf5a3d0aaa41ee2" providerId="LiveId" clId="{7614391D-DE7E-4F76-8922-D2DB3F3D93D6}" dt="2025-08-11T15:20:07.254" v="27" actId="21"/>
          <ac:picMkLst>
            <pc:docMk/>
            <pc:sldMk cId="1704906247" sldId="287"/>
            <ac:picMk id="3" creationId="{A2D6E613-49BD-1FE4-9EBD-FAB586423914}"/>
          </ac:picMkLst>
        </pc:picChg>
      </pc:sldChg>
      <pc:sldChg chg="addSp delSp modSp add del mod">
        <pc:chgData name="Francesca Trespidi" userId="fcf5a3d0aaa41ee2" providerId="LiveId" clId="{7614391D-DE7E-4F76-8922-D2DB3F3D93D6}" dt="2025-08-11T16:40:06.312" v="114" actId="47"/>
        <pc:sldMkLst>
          <pc:docMk/>
          <pc:sldMk cId="2558644567" sldId="287"/>
        </pc:sldMkLst>
        <pc:graphicFrameChg chg="add del mod">
          <ac:chgData name="Francesca Trespidi" userId="fcf5a3d0aaa41ee2" providerId="LiveId" clId="{7614391D-DE7E-4F76-8922-D2DB3F3D93D6}" dt="2025-08-11T16:36:45.392" v="74" actId="21"/>
          <ac:graphicFrameMkLst>
            <pc:docMk/>
            <pc:sldMk cId="2558644567" sldId="287"/>
            <ac:graphicFrameMk id="2" creationId="{CA06BAEA-8520-B651-017E-4AD768DF57BE}"/>
          </ac:graphicFrameMkLst>
        </pc:graphicFrameChg>
        <pc:picChg chg="add mod">
          <ac:chgData name="Francesca Trespidi" userId="fcf5a3d0aaa41ee2" providerId="LiveId" clId="{7614391D-DE7E-4F76-8922-D2DB3F3D93D6}" dt="2025-08-11T16:37:01.324" v="78" actId="14100"/>
          <ac:picMkLst>
            <pc:docMk/>
            <pc:sldMk cId="2558644567" sldId="287"/>
            <ac:picMk id="3" creationId="{9E7BA872-FD16-997A-E51E-9DD25F678AED}"/>
          </ac:picMkLst>
        </pc:picChg>
        <pc:picChg chg="add mod">
          <ac:chgData name="Francesca Trespidi" userId="fcf5a3d0aaa41ee2" providerId="LiveId" clId="{7614391D-DE7E-4F76-8922-D2DB3F3D93D6}" dt="2025-08-11T16:37:11.604" v="82" actId="1076"/>
          <ac:picMkLst>
            <pc:docMk/>
            <pc:sldMk cId="2558644567" sldId="287"/>
            <ac:picMk id="4" creationId="{9FA7D0C2-8ED6-787C-F333-14964506D887}"/>
          </ac:picMkLst>
        </pc:picChg>
        <pc:picChg chg="add mod">
          <ac:chgData name="Francesca Trespidi" userId="fcf5a3d0aaa41ee2" providerId="LiveId" clId="{7614391D-DE7E-4F76-8922-D2DB3F3D93D6}" dt="2025-08-11T16:37:39.435" v="89" actId="14100"/>
          <ac:picMkLst>
            <pc:docMk/>
            <pc:sldMk cId="2558644567" sldId="287"/>
            <ac:picMk id="5" creationId="{48FFC551-8310-4C78-E537-0E5C580CAA72}"/>
          </ac:picMkLst>
        </pc:picChg>
        <pc:picChg chg="add mod">
          <ac:chgData name="Francesca Trespidi" userId="fcf5a3d0aaa41ee2" providerId="LiveId" clId="{7614391D-DE7E-4F76-8922-D2DB3F3D93D6}" dt="2025-08-11T16:37:59.612" v="95" actId="1076"/>
          <ac:picMkLst>
            <pc:docMk/>
            <pc:sldMk cId="2558644567" sldId="287"/>
            <ac:picMk id="6" creationId="{6CE80898-42DB-0851-6D9E-83BD81E0EC19}"/>
          </ac:picMkLst>
        </pc:picChg>
        <pc:picChg chg="add mod">
          <ac:chgData name="Francesca Trespidi" userId="fcf5a3d0aaa41ee2" providerId="LiveId" clId="{7614391D-DE7E-4F76-8922-D2DB3F3D93D6}" dt="2025-08-11T16:38:11.293" v="100" actId="1076"/>
          <ac:picMkLst>
            <pc:docMk/>
            <pc:sldMk cId="2558644567" sldId="287"/>
            <ac:picMk id="7" creationId="{759A911E-269D-8920-719E-D93970FCA10A}"/>
          </ac:picMkLst>
        </pc:picChg>
        <pc:picChg chg="add mod">
          <ac:chgData name="Francesca Trespidi" userId="fcf5a3d0aaa41ee2" providerId="LiveId" clId="{7614391D-DE7E-4F76-8922-D2DB3F3D93D6}" dt="2025-08-11T16:38:30.019" v="106" actId="14100"/>
          <ac:picMkLst>
            <pc:docMk/>
            <pc:sldMk cId="2558644567" sldId="287"/>
            <ac:picMk id="8" creationId="{30AC7399-28D3-CBAC-E6DA-79C539D908A3}"/>
          </ac:picMkLst>
        </pc:picChg>
      </pc:sldChg>
      <pc:sldChg chg="addSp modSp add del mod">
        <pc:chgData name="Francesca Trespidi" userId="fcf5a3d0aaa41ee2" providerId="LiveId" clId="{7614391D-DE7E-4F76-8922-D2DB3F3D93D6}" dt="2025-08-12T10:40:31.673" v="488" actId="47"/>
        <pc:sldMkLst>
          <pc:docMk/>
          <pc:sldMk cId="3079712913" sldId="287"/>
        </pc:sldMkLst>
        <pc:spChg chg="add mod">
          <ac:chgData name="Francesca Trespidi" userId="fcf5a3d0aaa41ee2" providerId="LiveId" clId="{7614391D-DE7E-4F76-8922-D2DB3F3D93D6}" dt="2025-08-12T10:01:32.517" v="479" actId="1076"/>
          <ac:spMkLst>
            <pc:docMk/>
            <pc:sldMk cId="3079712913" sldId="287"/>
            <ac:spMk id="12" creationId="{70716B3D-95AF-7D3B-86FD-1FE2F1315575}"/>
          </ac:spMkLst>
        </pc:spChg>
        <pc:spChg chg="add mod">
          <ac:chgData name="Francesca Trespidi" userId="fcf5a3d0aaa41ee2" providerId="LiveId" clId="{7614391D-DE7E-4F76-8922-D2DB3F3D93D6}" dt="2025-08-12T10:01:45.278" v="484" actId="1076"/>
          <ac:spMkLst>
            <pc:docMk/>
            <pc:sldMk cId="3079712913" sldId="287"/>
            <ac:spMk id="17" creationId="{0114594B-95CF-059B-B76E-A0F2052DC1A0}"/>
          </ac:spMkLst>
        </pc:spChg>
        <pc:spChg chg="mod">
          <ac:chgData name="Francesca Trespidi" userId="fcf5a3d0aaa41ee2" providerId="LiveId" clId="{7614391D-DE7E-4F76-8922-D2DB3F3D93D6}" dt="2025-08-12T10:01:37.330" v="482" actId="1076"/>
          <ac:spMkLst>
            <pc:docMk/>
            <pc:sldMk cId="3079712913" sldId="287"/>
            <ac:spMk id="18" creationId="{44AC8B19-B534-D4CD-BE13-1842BE3B5A8E}"/>
          </ac:spMkLst>
        </pc:spChg>
        <pc:spChg chg="mod">
          <ac:chgData name="Francesca Trespidi" userId="fcf5a3d0aaa41ee2" providerId="LiveId" clId="{7614391D-DE7E-4F76-8922-D2DB3F3D93D6}" dt="2025-08-12T10:01:13.610" v="477" actId="1076"/>
          <ac:spMkLst>
            <pc:docMk/>
            <pc:sldMk cId="3079712913" sldId="287"/>
            <ac:spMk id="26" creationId="{39CFE851-362F-E31F-135D-ECC32140E945}"/>
          </ac:spMkLst>
        </pc:spChg>
        <pc:spChg chg="mod">
          <ac:chgData name="Francesca Trespidi" userId="fcf5a3d0aaa41ee2" providerId="LiveId" clId="{7614391D-DE7E-4F76-8922-D2DB3F3D93D6}" dt="2025-08-12T10:01:00.977" v="473" actId="1076"/>
          <ac:spMkLst>
            <pc:docMk/>
            <pc:sldMk cId="3079712913" sldId="287"/>
            <ac:spMk id="32" creationId="{CE1E855A-883F-567F-247D-8DD68C13F398}"/>
          </ac:spMkLst>
        </pc:spChg>
        <pc:picChg chg="mod">
          <ac:chgData name="Francesca Trespidi" userId="fcf5a3d0aaa41ee2" providerId="LiveId" clId="{7614391D-DE7E-4F76-8922-D2DB3F3D93D6}" dt="2025-08-12T10:00:34.276" v="468" actId="1076"/>
          <ac:picMkLst>
            <pc:docMk/>
            <pc:sldMk cId="3079712913" sldId="287"/>
            <ac:picMk id="5" creationId="{C322DA2E-DB87-6717-9CD6-253117A3E135}"/>
          </ac:picMkLst>
        </pc:picChg>
        <pc:picChg chg="mod">
          <ac:chgData name="Francesca Trespidi" userId="fcf5a3d0aaa41ee2" providerId="LiveId" clId="{7614391D-DE7E-4F76-8922-D2DB3F3D93D6}" dt="2025-08-12T10:00:44.547" v="469" actId="1076"/>
          <ac:picMkLst>
            <pc:docMk/>
            <pc:sldMk cId="3079712913" sldId="287"/>
            <ac:picMk id="6" creationId="{A7486BBD-0060-EAC2-C3D4-56BBEE0B1C48}"/>
          </ac:picMkLst>
        </pc:picChg>
        <pc:cxnChg chg="mod">
          <ac:chgData name="Francesca Trespidi" userId="fcf5a3d0aaa41ee2" providerId="LiveId" clId="{7614391D-DE7E-4F76-8922-D2DB3F3D93D6}" dt="2025-08-12T10:01:08.531" v="476" actId="1076"/>
          <ac:cxnSpMkLst>
            <pc:docMk/>
            <pc:sldMk cId="3079712913" sldId="287"/>
            <ac:cxnSpMk id="8" creationId="{99DAE1C5-0832-2B7D-ABA3-36064054EFA9}"/>
          </ac:cxnSpMkLst>
        </pc:cxnChg>
        <pc:cxnChg chg="add mod">
          <ac:chgData name="Francesca Trespidi" userId="fcf5a3d0aaa41ee2" providerId="LiveId" clId="{7614391D-DE7E-4F76-8922-D2DB3F3D93D6}" dt="2025-08-12T10:01:32.517" v="479" actId="1076"/>
          <ac:cxnSpMkLst>
            <pc:docMk/>
            <pc:sldMk cId="3079712913" sldId="287"/>
            <ac:cxnSpMk id="11" creationId="{9B426821-5FA5-F259-C307-F6DA51B86409}"/>
          </ac:cxnSpMkLst>
        </pc:cxnChg>
        <pc:cxnChg chg="mod">
          <ac:chgData name="Francesca Trespidi" userId="fcf5a3d0aaa41ee2" providerId="LiveId" clId="{7614391D-DE7E-4F76-8922-D2DB3F3D93D6}" dt="2025-08-12T10:01:34.954" v="480" actId="1076"/>
          <ac:cxnSpMkLst>
            <pc:docMk/>
            <pc:sldMk cId="3079712913" sldId="287"/>
            <ac:cxnSpMk id="16" creationId="{13C92ADB-0B93-2307-1C95-A8ABBBA1B11C}"/>
          </ac:cxnSpMkLst>
        </pc:cxnChg>
        <pc:cxnChg chg="add mod">
          <ac:chgData name="Francesca Trespidi" userId="fcf5a3d0aaa41ee2" providerId="LiveId" clId="{7614391D-DE7E-4F76-8922-D2DB3F3D93D6}" dt="2025-08-12T10:01:45.278" v="484" actId="1076"/>
          <ac:cxnSpMkLst>
            <pc:docMk/>
            <pc:sldMk cId="3079712913" sldId="287"/>
            <ac:cxnSpMk id="19" creationId="{8C21553B-E51D-9B49-5837-98129ECF33DC}"/>
          </ac:cxnSpMkLst>
        </pc:cxnChg>
      </pc:sldChg>
      <pc:sldChg chg="addSp delSp modSp add del mod">
        <pc:chgData name="Francesca Trespidi" userId="fcf5a3d0aaa41ee2" providerId="LiveId" clId="{7614391D-DE7E-4F76-8922-D2DB3F3D93D6}" dt="2025-08-11T15:22:15.373" v="44" actId="47"/>
        <pc:sldMkLst>
          <pc:docMk/>
          <pc:sldMk cId="3385194248" sldId="287"/>
        </pc:sldMkLst>
        <pc:graphicFrameChg chg="add del mod">
          <ac:chgData name="Francesca Trespidi" userId="fcf5a3d0aaa41ee2" providerId="LiveId" clId="{7614391D-DE7E-4F76-8922-D2DB3F3D93D6}" dt="2025-08-11T15:21:58.913" v="40" actId="21"/>
          <ac:graphicFrameMkLst>
            <pc:docMk/>
            <pc:sldMk cId="3385194248" sldId="287"/>
            <ac:graphicFrameMk id="2" creationId="{B783B33B-FFAB-44E4-2648-5E36797C0733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7:41.624" v="232" actId="47"/>
        <pc:sldMkLst>
          <pc:docMk/>
          <pc:sldMk cId="3605809173" sldId="287"/>
        </pc:sldMkLst>
        <pc:graphicFrameChg chg="add del mod">
          <ac:chgData name="Francesca Trespidi" userId="fcf5a3d0aaa41ee2" providerId="LiveId" clId="{7614391D-DE7E-4F76-8922-D2DB3F3D93D6}" dt="2025-08-11T16:47:34.383" v="125" actId="21"/>
          <ac:graphicFrameMkLst>
            <pc:docMk/>
            <pc:sldMk cId="3605809173" sldId="287"/>
            <ac:graphicFrameMk id="2" creationId="{20FF1ED4-8C4B-82C5-C806-5C1666881032}"/>
          </ac:graphicFrameMkLst>
        </pc:graphicFrameChg>
        <pc:picChg chg="add del mod">
          <ac:chgData name="Francesca Trespidi" userId="fcf5a3d0aaa41ee2" providerId="LiveId" clId="{7614391D-DE7E-4F76-8922-D2DB3F3D93D6}" dt="2025-08-11T16:52:42.742" v="187" actId="478"/>
          <ac:picMkLst>
            <pc:docMk/>
            <pc:sldMk cId="3605809173" sldId="287"/>
            <ac:picMk id="3" creationId="{4AC5FCD5-A05F-54C5-A20D-2D673AF5147A}"/>
          </ac:picMkLst>
        </pc:picChg>
        <pc:picChg chg="add mod">
          <ac:chgData name="Francesca Trespidi" userId="fcf5a3d0aaa41ee2" providerId="LiveId" clId="{7614391D-DE7E-4F76-8922-D2DB3F3D93D6}" dt="2025-08-11T16:48:54.850" v="139" actId="14100"/>
          <ac:picMkLst>
            <pc:docMk/>
            <pc:sldMk cId="3605809173" sldId="287"/>
            <ac:picMk id="4" creationId="{C708CCC9-1B17-5C5C-32FF-7864D33D5E87}"/>
          </ac:picMkLst>
        </pc:picChg>
        <pc:picChg chg="add del mod">
          <ac:chgData name="Francesca Trespidi" userId="fcf5a3d0aaa41ee2" providerId="LiveId" clId="{7614391D-DE7E-4F76-8922-D2DB3F3D93D6}" dt="2025-08-11T16:52:51.750" v="189" actId="478"/>
          <ac:picMkLst>
            <pc:docMk/>
            <pc:sldMk cId="3605809173" sldId="287"/>
            <ac:picMk id="5" creationId="{E2B7A696-0643-2FA5-501C-DB0DD6EDBB45}"/>
          </ac:picMkLst>
        </pc:picChg>
        <pc:picChg chg="add mod">
          <ac:chgData name="Francesca Trespidi" userId="fcf5a3d0aaa41ee2" providerId="LiveId" clId="{7614391D-DE7E-4F76-8922-D2DB3F3D93D6}" dt="2025-08-11T16:51:33.809" v="180" actId="1076"/>
          <ac:picMkLst>
            <pc:docMk/>
            <pc:sldMk cId="3605809173" sldId="287"/>
            <ac:picMk id="6" creationId="{F9403E1E-F476-1FCE-1971-274136FDD89E}"/>
          </ac:picMkLst>
        </pc:picChg>
        <pc:picChg chg="add mod">
          <ac:chgData name="Francesca Trespidi" userId="fcf5a3d0aaa41ee2" providerId="LiveId" clId="{7614391D-DE7E-4F76-8922-D2DB3F3D93D6}" dt="2025-08-11T16:52:47.122" v="188" actId="1076"/>
          <ac:picMkLst>
            <pc:docMk/>
            <pc:sldMk cId="3605809173" sldId="287"/>
            <ac:picMk id="7" creationId="{AD3123D2-79C8-F7DA-B7C5-2762DC7CE984}"/>
          </ac:picMkLst>
        </pc:picChg>
        <pc:picChg chg="add mod">
          <ac:chgData name="Francesca Trespidi" userId="fcf5a3d0aaa41ee2" providerId="LiveId" clId="{7614391D-DE7E-4F76-8922-D2DB3F3D93D6}" dt="2025-08-11T16:53:33.639" v="200" actId="1076"/>
          <ac:picMkLst>
            <pc:docMk/>
            <pc:sldMk cId="3605809173" sldId="287"/>
            <ac:picMk id="8" creationId="{FFA06547-013B-37D0-1727-3D2E4946C6C4}"/>
          </ac:picMkLst>
        </pc:picChg>
        <pc:picChg chg="add mod">
          <ac:chgData name="Francesca Trespidi" userId="fcf5a3d0aaa41ee2" providerId="LiveId" clId="{7614391D-DE7E-4F76-8922-D2DB3F3D93D6}" dt="2025-08-11T16:53:56.880" v="209" actId="1076"/>
          <ac:picMkLst>
            <pc:docMk/>
            <pc:sldMk cId="3605809173" sldId="287"/>
            <ac:picMk id="9" creationId="{27015D4F-7737-27D0-B6DF-17C06E19C951}"/>
          </ac:picMkLst>
        </pc:picChg>
        <pc:picChg chg="add mod">
          <ac:chgData name="Francesca Trespidi" userId="fcf5a3d0aaa41ee2" providerId="LiveId" clId="{7614391D-DE7E-4F76-8922-D2DB3F3D93D6}" dt="2025-08-11T16:56:34.113" v="219" actId="1076"/>
          <ac:picMkLst>
            <pc:docMk/>
            <pc:sldMk cId="3605809173" sldId="287"/>
            <ac:picMk id="10" creationId="{A83D8480-4978-F176-B26E-D28009DF1709}"/>
          </ac:picMkLst>
        </pc:picChg>
      </pc:sldChg>
      <pc:sldChg chg="addSp modSp add del">
        <pc:chgData name="Francesca Trespidi" userId="fcf5a3d0aaa41ee2" providerId="LiveId" clId="{7614391D-DE7E-4F76-8922-D2DB3F3D93D6}" dt="2025-08-11T15:33:39.703" v="49" actId="47"/>
        <pc:sldMkLst>
          <pc:docMk/>
          <pc:sldMk cId="3658725932" sldId="287"/>
        </pc:sldMkLst>
        <pc:graphicFrameChg chg="add mod">
          <ac:chgData name="Francesca Trespidi" userId="fcf5a3d0aaa41ee2" providerId="LiveId" clId="{7614391D-DE7E-4F76-8922-D2DB3F3D93D6}" dt="2025-08-11T15:23:31.830" v="46"/>
          <ac:graphicFrameMkLst>
            <pc:docMk/>
            <pc:sldMk cId="3658725932" sldId="287"/>
            <ac:graphicFrameMk id="2" creationId="{6D566CA2-94F7-142C-CE44-A380191FF6FB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49:35.421" v="146" actId="47"/>
        <pc:sldMkLst>
          <pc:docMk/>
          <pc:sldMk cId="511791728" sldId="288"/>
        </pc:sldMkLst>
        <pc:graphicFrameChg chg="add del mod">
          <ac:chgData name="Francesca Trespidi" userId="fcf5a3d0aaa41ee2" providerId="LiveId" clId="{7614391D-DE7E-4F76-8922-D2DB3F3D93D6}" dt="2025-08-11T16:47:48.472" v="131" actId="21"/>
          <ac:graphicFrameMkLst>
            <pc:docMk/>
            <pc:sldMk cId="511791728" sldId="288"/>
            <ac:graphicFrameMk id="2" creationId="{0B91A008-87C7-4CF0-A77E-7E478582B57C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37:41.960" v="90" actId="47"/>
        <pc:sldMkLst>
          <pc:docMk/>
          <pc:sldMk cId="1229949237" sldId="288"/>
        </pc:sldMkLst>
        <pc:graphicFrameChg chg="add del mod">
          <ac:chgData name="Francesca Trespidi" userId="fcf5a3d0aaa41ee2" providerId="LiveId" clId="{7614391D-DE7E-4F76-8922-D2DB3F3D93D6}" dt="2025-08-11T16:37:04.042" v="79" actId="21"/>
          <ac:graphicFrameMkLst>
            <pc:docMk/>
            <pc:sldMk cId="1229949237" sldId="288"/>
            <ac:graphicFrameMk id="2" creationId="{3CB28542-FC59-B049-D90B-80A1A52C8CD5}"/>
          </ac:graphicFrameMkLst>
        </pc:graphicFrameChg>
      </pc:sldChg>
      <pc:sldChg chg="add del">
        <pc:chgData name="Francesca Trespidi" userId="fcf5a3d0aaa41ee2" providerId="LiveId" clId="{7614391D-DE7E-4F76-8922-D2DB3F3D93D6}" dt="2025-08-11T15:20:03.137" v="25" actId="2890"/>
        <pc:sldMkLst>
          <pc:docMk/>
          <pc:sldMk cId="1919094811" sldId="288"/>
        </pc:sldMkLst>
      </pc:sldChg>
      <pc:sldChg chg="addSp delSp modSp add del mod">
        <pc:chgData name="Francesca Trespidi" userId="fcf5a3d0aaa41ee2" providerId="LiveId" clId="{7614391D-DE7E-4F76-8922-D2DB3F3D93D6}" dt="2025-08-11T15:34:15.139" v="59" actId="47"/>
        <pc:sldMkLst>
          <pc:docMk/>
          <pc:sldMk cId="3072952600" sldId="288"/>
        </pc:sldMkLst>
        <pc:graphicFrameChg chg="add del mod">
          <ac:chgData name="Francesca Trespidi" userId="fcf5a3d0aaa41ee2" providerId="LiveId" clId="{7614391D-DE7E-4F76-8922-D2DB3F3D93D6}" dt="2025-08-11T15:33:42.933" v="50" actId="21"/>
          <ac:graphicFrameMkLst>
            <pc:docMk/>
            <pc:sldMk cId="3072952600" sldId="288"/>
            <ac:graphicFrameMk id="2" creationId="{88DEEA74-0D74-0AD0-6862-E1D2111E7550}"/>
          </ac:graphicFrameMkLst>
        </pc:graphicFrameChg>
        <pc:picChg chg="add del mod">
          <ac:chgData name="Francesca Trespidi" userId="fcf5a3d0aaa41ee2" providerId="LiveId" clId="{7614391D-DE7E-4F76-8922-D2DB3F3D93D6}" dt="2025-08-11T15:34:03.378" v="54" actId="21"/>
          <ac:picMkLst>
            <pc:docMk/>
            <pc:sldMk cId="3072952600" sldId="288"/>
            <ac:picMk id="3" creationId="{14D0723F-D73A-D16A-9515-5AA2684340F8}"/>
          </ac:picMkLst>
        </pc:picChg>
      </pc:sldChg>
      <pc:sldChg chg="addSp delSp modSp add del mod">
        <pc:chgData name="Francesca Trespidi" userId="fcf5a3d0aaa41ee2" providerId="LiveId" clId="{7614391D-DE7E-4F76-8922-D2DB3F3D93D6}" dt="2025-08-12T09:10:33.068" v="400" actId="47"/>
        <pc:sldMkLst>
          <pc:docMk/>
          <pc:sldMk cId="4054075085" sldId="288"/>
        </pc:sldMkLst>
        <pc:graphicFrameChg chg="add del mod">
          <ac:chgData name="Francesca Trespidi" userId="fcf5a3d0aaa41ee2" providerId="LiveId" clId="{7614391D-DE7E-4F76-8922-D2DB3F3D93D6}" dt="2025-08-12T09:09:47.806" v="388" actId="21"/>
          <ac:graphicFrameMkLst>
            <pc:docMk/>
            <pc:sldMk cId="4054075085" sldId="288"/>
            <ac:graphicFrameMk id="2" creationId="{97D978CD-B042-0FD9-FA28-937470673D1D}"/>
          </ac:graphicFrameMkLst>
        </pc:graphicFrameChg>
        <pc:picChg chg="add mod modCrop">
          <ac:chgData name="Francesca Trespidi" userId="fcf5a3d0aaa41ee2" providerId="LiveId" clId="{7614391D-DE7E-4F76-8922-D2DB3F3D93D6}" dt="2025-08-12T09:09:53.996" v="390" actId="732"/>
          <ac:picMkLst>
            <pc:docMk/>
            <pc:sldMk cId="4054075085" sldId="288"/>
            <ac:picMk id="3" creationId="{8D5C03E3-A9BB-92DD-C948-61B24ED0103E}"/>
          </ac:picMkLst>
        </pc:picChg>
      </pc:sldChg>
      <pc:sldChg chg="addSp delSp modSp add del mod">
        <pc:chgData name="Francesca Trespidi" userId="fcf5a3d0aaa41ee2" providerId="LiveId" clId="{7614391D-DE7E-4F76-8922-D2DB3F3D93D6}" dt="2025-08-11T16:37:42.451" v="91" actId="47"/>
        <pc:sldMkLst>
          <pc:docMk/>
          <pc:sldMk cId="2377075407" sldId="289"/>
        </pc:sldMkLst>
        <pc:graphicFrameChg chg="add del mod">
          <ac:chgData name="Francesca Trespidi" userId="fcf5a3d0aaa41ee2" providerId="LiveId" clId="{7614391D-DE7E-4F76-8922-D2DB3F3D93D6}" dt="2025-08-11T16:37:16.871" v="83" actId="21"/>
          <ac:graphicFrameMkLst>
            <pc:docMk/>
            <pc:sldMk cId="2377075407" sldId="289"/>
            <ac:graphicFrameMk id="2" creationId="{01A1BE30-0767-4CDB-0993-77C72D70B9AF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0:50.328" v="169" actId="47"/>
        <pc:sldMkLst>
          <pc:docMk/>
          <pc:sldMk cId="2456623681" sldId="289"/>
        </pc:sldMkLst>
        <pc:graphicFrameChg chg="add del mod">
          <ac:chgData name="Francesca Trespidi" userId="fcf5a3d0aaa41ee2" providerId="LiveId" clId="{7614391D-DE7E-4F76-8922-D2DB3F3D93D6}" dt="2025-08-11T16:49:37.007" v="147" actId="21"/>
          <ac:graphicFrameMkLst>
            <pc:docMk/>
            <pc:sldMk cId="2456623681" sldId="289"/>
            <ac:graphicFrameMk id="2" creationId="{E3B3EC02-729E-D17F-FEF8-96B53B170A9C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3:38.781" v="203" actId="47"/>
        <pc:sldMkLst>
          <pc:docMk/>
          <pc:sldMk cId="811617576" sldId="290"/>
        </pc:sldMkLst>
        <pc:graphicFrameChg chg="add del mod">
          <ac:chgData name="Francesca Trespidi" userId="fcf5a3d0aaa41ee2" providerId="LiveId" clId="{7614391D-DE7E-4F76-8922-D2DB3F3D93D6}" dt="2025-08-11T16:50:52.095" v="170" actId="21"/>
          <ac:graphicFrameMkLst>
            <pc:docMk/>
            <pc:sldMk cId="811617576" sldId="290"/>
            <ac:graphicFrameMk id="2" creationId="{6933FBCF-3698-9ED1-193C-3E06A50A1C3E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38:02.051" v="96" actId="47"/>
        <pc:sldMkLst>
          <pc:docMk/>
          <pc:sldMk cId="4192009383" sldId="290"/>
        </pc:sldMkLst>
        <pc:graphicFrameChg chg="add del mod">
          <ac:chgData name="Francesca Trespidi" userId="fcf5a3d0aaa41ee2" providerId="LiveId" clId="{7614391D-DE7E-4F76-8922-D2DB3F3D93D6}" dt="2025-08-11T16:37:44.045" v="92" actId="21"/>
          <ac:graphicFrameMkLst>
            <pc:docMk/>
            <pc:sldMk cId="4192009383" sldId="290"/>
            <ac:graphicFrameMk id="2" creationId="{88B1D482-665A-F8E2-8EB0-29CF74FF76D3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3:59.600" v="210" actId="47"/>
        <pc:sldMkLst>
          <pc:docMk/>
          <pc:sldMk cId="233634752" sldId="291"/>
        </pc:sldMkLst>
        <pc:graphicFrameChg chg="add del mod">
          <ac:chgData name="Francesca Trespidi" userId="fcf5a3d0aaa41ee2" providerId="LiveId" clId="{7614391D-DE7E-4F76-8922-D2DB3F3D93D6}" dt="2025-08-11T16:53:40.877" v="204" actId="21"/>
          <ac:graphicFrameMkLst>
            <pc:docMk/>
            <pc:sldMk cId="233634752" sldId="291"/>
            <ac:graphicFrameMk id="2" creationId="{469542FF-563D-8ECF-4D4E-0C6DFA6E8259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38:33.741" v="107" actId="47"/>
        <pc:sldMkLst>
          <pc:docMk/>
          <pc:sldMk cId="1743964473" sldId="291"/>
        </pc:sldMkLst>
        <pc:graphicFrameChg chg="add del mod">
          <ac:chgData name="Francesca Trespidi" userId="fcf5a3d0aaa41ee2" providerId="LiveId" clId="{7614391D-DE7E-4F76-8922-D2DB3F3D93D6}" dt="2025-08-11T16:38:03.808" v="97" actId="21"/>
          <ac:graphicFrameMkLst>
            <pc:docMk/>
            <pc:sldMk cId="1743964473" sldId="291"/>
            <ac:graphicFrameMk id="2" creationId="{228060E4-5780-2037-A771-4D7176774370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3:38.214" v="202" actId="47"/>
        <pc:sldMkLst>
          <pc:docMk/>
          <pc:sldMk cId="3739269487" sldId="292"/>
        </pc:sldMkLst>
        <pc:graphicFrameChg chg="add del mod">
          <ac:chgData name="Francesca Trespidi" userId="fcf5a3d0aaa41ee2" providerId="LiveId" clId="{7614391D-DE7E-4F76-8922-D2DB3F3D93D6}" dt="2025-08-11T16:52:21.649" v="183" actId="21"/>
          <ac:graphicFrameMkLst>
            <pc:docMk/>
            <pc:sldMk cId="3739269487" sldId="292"/>
            <ac:graphicFrameMk id="2" creationId="{2484EED3-37B8-DC8D-00C0-27300B44C5BE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38:34.234" v="108" actId="47"/>
        <pc:sldMkLst>
          <pc:docMk/>
          <pc:sldMk cId="4117034035" sldId="292"/>
        </pc:sldMkLst>
        <pc:graphicFrameChg chg="add del mod">
          <ac:chgData name="Francesca Trespidi" userId="fcf5a3d0aaa41ee2" providerId="LiveId" clId="{7614391D-DE7E-4F76-8922-D2DB3F3D93D6}" dt="2025-08-11T16:38:12.960" v="101" actId="21"/>
          <ac:graphicFrameMkLst>
            <pc:docMk/>
            <pc:sldMk cId="4117034035" sldId="292"/>
            <ac:graphicFrameMk id="2" creationId="{B0D37665-C730-B42B-ACE1-6931051313BB}"/>
          </ac:graphicFrameMkLst>
        </pc:graphicFrameChg>
      </pc:sldChg>
      <pc:sldChg chg="addSp delSp modSp add del mod">
        <pc:chgData name="Francesca Trespidi" userId="fcf5a3d0aaa41ee2" providerId="LiveId" clId="{7614391D-DE7E-4F76-8922-D2DB3F3D93D6}" dt="2025-08-11T16:53:37.636" v="201" actId="47"/>
        <pc:sldMkLst>
          <pc:docMk/>
          <pc:sldMk cId="3699230217" sldId="293"/>
        </pc:sldMkLst>
        <pc:graphicFrameChg chg="add del mod">
          <ac:chgData name="Francesca Trespidi" userId="fcf5a3d0aaa41ee2" providerId="LiveId" clId="{7614391D-DE7E-4F76-8922-D2DB3F3D93D6}" dt="2025-08-11T16:53:10.324" v="192" actId="21"/>
          <ac:graphicFrameMkLst>
            <pc:docMk/>
            <pc:sldMk cId="3699230217" sldId="293"/>
            <ac:graphicFrameMk id="2" creationId="{368857A4-2B0E-2C58-4618-5F89D45E722E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309B1-F4E1-4F38-8242-CE78FFFDB558}" type="datetimeFigureOut">
              <a:rPr lang="en-US" smtClean="0"/>
              <a:t>8/20/25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744B4DE-81AC-44FC-9FA1-392664D206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0335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8459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5858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62031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0954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721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2421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41889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7448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0858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30000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2311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B87FA7-871A-4080-8F30-0A575B02EC99}" type="datetimeFigureOut">
              <a:rPr lang="en-US" smtClean="0"/>
              <a:t>8/20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930719-CE76-469E-B354-927EA035FD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04692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7" Type="http://schemas.openxmlformats.org/officeDocument/2006/relationships/image" Target="../media/image10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416045B0-73C5-F5B8-CB37-CEAEFE3F21DF}"/>
              </a:ext>
            </a:extLst>
          </p:cNvPr>
          <p:cNvSpPr txBox="1"/>
          <p:nvPr/>
        </p:nvSpPr>
        <p:spPr>
          <a:xfrm>
            <a:off x="1715494" y="1808898"/>
            <a:ext cx="342701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b="1" dirty="0"/>
              <a:t>Supplemental 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204406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159F870-4729-E5D8-FE5B-9B01F342A33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asellaDiTesto 7">
            <a:extLst>
              <a:ext uri="{FF2B5EF4-FFF2-40B4-BE49-F238E27FC236}">
                <a16:creationId xmlns:a16="http://schemas.microsoft.com/office/drawing/2014/main" id="{ACE45BAA-ED4C-E5FD-21A9-228ACCBCDF3B}"/>
              </a:ext>
            </a:extLst>
          </p:cNvPr>
          <p:cNvSpPr txBox="1"/>
          <p:nvPr/>
        </p:nvSpPr>
        <p:spPr>
          <a:xfrm>
            <a:off x="319878" y="4900461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E</a:t>
            </a:r>
            <a:endParaRPr lang="en-US" sz="12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2F5C8F10-D2D6-9684-3BC2-65EEC8E4C52B}"/>
              </a:ext>
            </a:extLst>
          </p:cNvPr>
          <p:cNvSpPr txBox="1"/>
          <p:nvPr/>
        </p:nvSpPr>
        <p:spPr>
          <a:xfrm>
            <a:off x="3173802" y="4900461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</a:t>
            </a:r>
            <a:endParaRPr lang="en-US" sz="1200" dirty="0"/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9A0BC1B5-2654-D82A-82BD-432790FCB959}"/>
              </a:ext>
            </a:extLst>
          </p:cNvPr>
          <p:cNvSpPr txBox="1"/>
          <p:nvPr/>
        </p:nvSpPr>
        <p:spPr>
          <a:xfrm>
            <a:off x="319878" y="249101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C</a:t>
            </a:r>
            <a:endParaRPr lang="en-US" sz="1200" dirty="0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3FAB7164-18C9-CFAA-F692-2DF49E68B02E}"/>
              </a:ext>
            </a:extLst>
          </p:cNvPr>
          <p:cNvSpPr txBox="1"/>
          <p:nvPr/>
        </p:nvSpPr>
        <p:spPr>
          <a:xfrm>
            <a:off x="3112961" y="2446611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</a:t>
            </a:r>
            <a:endParaRPr lang="en-US" sz="1200" dirty="0"/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2FD65777-7E4D-1E28-DD85-C955B41C4F82}"/>
              </a:ext>
            </a:extLst>
          </p:cNvPr>
          <p:cNvSpPr txBox="1"/>
          <p:nvPr/>
        </p:nvSpPr>
        <p:spPr>
          <a:xfrm>
            <a:off x="325507" y="42209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en-US" sz="1200" dirty="0"/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E8D6534C-D305-FF6B-383B-96BCAA103437}"/>
              </a:ext>
            </a:extLst>
          </p:cNvPr>
          <p:cNvSpPr txBox="1"/>
          <p:nvPr/>
        </p:nvSpPr>
        <p:spPr>
          <a:xfrm>
            <a:off x="3118590" y="34990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</a:t>
            </a:r>
            <a:endParaRPr lang="en-US" sz="1200" dirty="0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7B8E31D2-B9DA-302A-6CB6-AC5F6D9732B0}"/>
              </a:ext>
            </a:extLst>
          </p:cNvPr>
          <p:cNvSpPr txBox="1"/>
          <p:nvPr/>
        </p:nvSpPr>
        <p:spPr>
          <a:xfrm>
            <a:off x="201600" y="7565759"/>
            <a:ext cx="6454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1.</a:t>
            </a:r>
            <a:endParaRPr lang="it-IT" sz="1200" dirty="0"/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58FAD5F6-52B8-A419-F470-CC2CCB6FB11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6806" y="492439"/>
            <a:ext cx="6161657" cy="68649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28825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D7413666-18E5-1EE4-1184-B0D8B82B46F6}"/>
              </a:ext>
            </a:extLst>
          </p:cNvPr>
          <p:cNvSpPr txBox="1"/>
          <p:nvPr/>
        </p:nvSpPr>
        <p:spPr>
          <a:xfrm>
            <a:off x="595295" y="50221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en-US" sz="1200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A0862FB9-C565-434D-C44C-C66624F2040B}"/>
              </a:ext>
            </a:extLst>
          </p:cNvPr>
          <p:cNvSpPr txBox="1"/>
          <p:nvPr/>
        </p:nvSpPr>
        <p:spPr>
          <a:xfrm>
            <a:off x="593693" y="2835849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</a:t>
            </a:r>
            <a:endParaRPr lang="en-US" sz="12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F1E5E7A2-FE82-F66D-D10E-6E442EDF7C66}"/>
              </a:ext>
            </a:extLst>
          </p:cNvPr>
          <p:cNvSpPr txBox="1"/>
          <p:nvPr/>
        </p:nvSpPr>
        <p:spPr>
          <a:xfrm>
            <a:off x="609177" y="532974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C</a:t>
            </a:r>
            <a:endParaRPr lang="en-US" sz="1200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9DD0951B-D963-4401-972A-29E970FB00A6}"/>
              </a:ext>
            </a:extLst>
          </p:cNvPr>
          <p:cNvSpPr txBox="1"/>
          <p:nvPr/>
        </p:nvSpPr>
        <p:spPr>
          <a:xfrm>
            <a:off x="593693" y="7870704"/>
            <a:ext cx="5667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2. </a:t>
            </a:r>
            <a:endParaRPr lang="en-US" sz="1200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A2D6E613-49BD-1FE4-9EBD-FAB5864239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4371" y="310896"/>
            <a:ext cx="5667411" cy="72140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03823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1A77AD83-7A30-FD98-00E9-B0805898C87A}"/>
              </a:ext>
            </a:extLst>
          </p:cNvPr>
          <p:cNvSpPr txBox="1"/>
          <p:nvPr/>
        </p:nvSpPr>
        <p:spPr>
          <a:xfrm>
            <a:off x="595295" y="699928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en-US" sz="1200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19B902C3-9840-304C-F042-9775AAEACC4F}"/>
              </a:ext>
            </a:extLst>
          </p:cNvPr>
          <p:cNvSpPr txBox="1"/>
          <p:nvPr/>
        </p:nvSpPr>
        <p:spPr>
          <a:xfrm>
            <a:off x="595295" y="2738197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</a:t>
            </a:r>
            <a:endParaRPr lang="en-US" sz="12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5D4735CE-5971-7B89-090A-85486300BC6A}"/>
              </a:ext>
            </a:extLst>
          </p:cNvPr>
          <p:cNvSpPr txBox="1"/>
          <p:nvPr/>
        </p:nvSpPr>
        <p:spPr>
          <a:xfrm>
            <a:off x="595295" y="4876191"/>
            <a:ext cx="57554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3. </a:t>
            </a:r>
            <a:endParaRPr lang="en-US" sz="1200" dirty="0"/>
          </a:p>
        </p:txBody>
      </p:sp>
      <p:pic>
        <p:nvPicPr>
          <p:cNvPr id="2" name="Immagine 1">
            <a:extLst>
              <a:ext uri="{FF2B5EF4-FFF2-40B4-BE49-F238E27FC236}">
                <a16:creationId xmlns:a16="http://schemas.microsoft.com/office/drawing/2014/main" id="{CA4FCC6C-37C0-19D8-D808-147A27CC24E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4157" y="872059"/>
            <a:ext cx="5908548" cy="37322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30292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sellaDiTesto 1">
            <a:extLst>
              <a:ext uri="{FF2B5EF4-FFF2-40B4-BE49-F238E27FC236}">
                <a16:creationId xmlns:a16="http://schemas.microsoft.com/office/drawing/2014/main" id="{56E589FA-3795-2F60-0DE4-A2F4FAB8A3E9}"/>
              </a:ext>
            </a:extLst>
          </p:cNvPr>
          <p:cNvSpPr txBox="1"/>
          <p:nvPr/>
        </p:nvSpPr>
        <p:spPr>
          <a:xfrm>
            <a:off x="595295" y="63576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en-US" sz="1200" dirty="0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DE485FA2-E740-B6B5-85DD-42903E61D59C}"/>
              </a:ext>
            </a:extLst>
          </p:cNvPr>
          <p:cNvSpPr txBox="1"/>
          <p:nvPr/>
        </p:nvSpPr>
        <p:spPr>
          <a:xfrm>
            <a:off x="3540513" y="635760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</a:t>
            </a:r>
            <a:endParaRPr lang="en-US" sz="1200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13A94D70-6F16-8A88-341A-3AC8496AECEE}"/>
              </a:ext>
            </a:extLst>
          </p:cNvPr>
          <p:cNvSpPr txBox="1"/>
          <p:nvPr/>
        </p:nvSpPr>
        <p:spPr>
          <a:xfrm>
            <a:off x="595295" y="5353297"/>
            <a:ext cx="56674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4. </a:t>
            </a:r>
            <a:endParaRPr lang="en-US" sz="12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3A569311-193B-190E-1712-2DAAF536BBB8}"/>
              </a:ext>
            </a:extLst>
          </p:cNvPr>
          <p:cNvSpPr txBox="1"/>
          <p:nvPr/>
        </p:nvSpPr>
        <p:spPr>
          <a:xfrm>
            <a:off x="598501" y="2714386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C</a:t>
            </a:r>
            <a:endParaRPr lang="en-US" sz="1200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2FD125A0-63BE-211B-9C91-762462F363F4}"/>
              </a:ext>
            </a:extLst>
          </p:cNvPr>
          <p:cNvSpPr txBox="1"/>
          <p:nvPr/>
        </p:nvSpPr>
        <p:spPr>
          <a:xfrm>
            <a:off x="3540513" y="27143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</a:t>
            </a:r>
            <a:endParaRPr lang="en-US" sz="1200" dirty="0"/>
          </a:p>
        </p:txBody>
      </p:sp>
      <p:pic>
        <p:nvPicPr>
          <p:cNvPr id="8" name="Immagine 7">
            <a:extLst>
              <a:ext uri="{FF2B5EF4-FFF2-40B4-BE49-F238E27FC236}">
                <a16:creationId xmlns:a16="http://schemas.microsoft.com/office/drawing/2014/main" id="{14D0723F-D73A-D16A-9515-5AA2684340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775" y="414731"/>
            <a:ext cx="6019572" cy="49385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596195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D3BD033F-B840-D648-E0B6-C61B9B58740D}"/>
              </a:ext>
            </a:extLst>
          </p:cNvPr>
          <p:cNvSpPr txBox="1"/>
          <p:nvPr/>
        </p:nvSpPr>
        <p:spPr>
          <a:xfrm>
            <a:off x="275162" y="4092944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E</a:t>
            </a:r>
            <a:endParaRPr lang="en-US" sz="1200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D32B081D-1B61-CE63-CE63-F6762F9CFC0D}"/>
              </a:ext>
            </a:extLst>
          </p:cNvPr>
          <p:cNvSpPr txBox="1"/>
          <p:nvPr/>
        </p:nvSpPr>
        <p:spPr>
          <a:xfrm>
            <a:off x="3458176" y="4105753"/>
            <a:ext cx="2551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F</a:t>
            </a:r>
            <a:endParaRPr lang="en-US" sz="1200" dirty="0"/>
          </a:p>
        </p:txBody>
      </p:sp>
      <p:sp>
        <p:nvSpPr>
          <p:cNvPr id="5" name="CasellaDiTesto 4">
            <a:extLst>
              <a:ext uri="{FF2B5EF4-FFF2-40B4-BE49-F238E27FC236}">
                <a16:creationId xmlns:a16="http://schemas.microsoft.com/office/drawing/2014/main" id="{D3134C7C-EFED-7886-05FA-DF04984EC0B6}"/>
              </a:ext>
            </a:extLst>
          </p:cNvPr>
          <p:cNvSpPr txBox="1"/>
          <p:nvPr/>
        </p:nvSpPr>
        <p:spPr>
          <a:xfrm>
            <a:off x="275162" y="2203385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C</a:t>
            </a:r>
            <a:endParaRPr lang="en-US" sz="1200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0BEA1575-8DF6-0479-1220-6109ED149AF2}"/>
              </a:ext>
            </a:extLst>
          </p:cNvPr>
          <p:cNvSpPr txBox="1"/>
          <p:nvPr/>
        </p:nvSpPr>
        <p:spPr>
          <a:xfrm>
            <a:off x="3488559" y="2203385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</a:t>
            </a:r>
            <a:endParaRPr lang="en-US" sz="1200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8EE4CEBF-C3EF-55A1-708D-3ACDE11DA7C5}"/>
              </a:ext>
            </a:extLst>
          </p:cNvPr>
          <p:cNvSpPr txBox="1"/>
          <p:nvPr/>
        </p:nvSpPr>
        <p:spPr>
          <a:xfrm>
            <a:off x="275162" y="175326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</a:t>
            </a:r>
            <a:endParaRPr lang="en-US" sz="1200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4817E3BF-4647-CE09-35A4-A9787BE3B379}"/>
              </a:ext>
            </a:extLst>
          </p:cNvPr>
          <p:cNvSpPr txBox="1"/>
          <p:nvPr/>
        </p:nvSpPr>
        <p:spPr>
          <a:xfrm>
            <a:off x="3451764" y="175326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B</a:t>
            </a:r>
            <a:endParaRPr lang="en-US" sz="1200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1E6CA0A1-3DED-F5F0-F401-B32074F894DE}"/>
              </a:ext>
            </a:extLst>
          </p:cNvPr>
          <p:cNvSpPr txBox="1"/>
          <p:nvPr/>
        </p:nvSpPr>
        <p:spPr>
          <a:xfrm>
            <a:off x="405166" y="6625687"/>
            <a:ext cx="58547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/>
              <a:t>Figure S5.</a:t>
            </a:r>
            <a:endParaRPr lang="it-IT" sz="1200" dirty="0"/>
          </a:p>
        </p:txBody>
      </p:sp>
      <p:grpSp>
        <p:nvGrpSpPr>
          <p:cNvPr id="16" name="Gruppo 15">
            <a:extLst>
              <a:ext uri="{FF2B5EF4-FFF2-40B4-BE49-F238E27FC236}">
                <a16:creationId xmlns:a16="http://schemas.microsoft.com/office/drawing/2014/main" id="{6D9C392D-3670-5740-FA50-B7042A09E46A}"/>
              </a:ext>
            </a:extLst>
          </p:cNvPr>
          <p:cNvGrpSpPr/>
          <p:nvPr/>
        </p:nvGrpSpPr>
        <p:grpSpPr>
          <a:xfrm>
            <a:off x="468545" y="452325"/>
            <a:ext cx="5875384" cy="5886713"/>
            <a:chOff x="491308" y="581548"/>
            <a:chExt cx="5875384" cy="5886713"/>
          </a:xfrm>
        </p:grpSpPr>
        <p:pic>
          <p:nvPicPr>
            <p:cNvPr id="2" name="Immagine 1">
              <a:extLst>
                <a:ext uri="{FF2B5EF4-FFF2-40B4-BE49-F238E27FC236}">
                  <a16:creationId xmlns:a16="http://schemas.microsoft.com/office/drawing/2014/main" id="{855DE70D-4073-D630-7276-B1642E614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91308" y="581548"/>
              <a:ext cx="2937691" cy="1574078"/>
            </a:xfrm>
            <a:prstGeom prst="rect">
              <a:avLst/>
            </a:prstGeom>
          </p:spPr>
        </p:pic>
        <p:pic>
          <p:nvPicPr>
            <p:cNvPr id="11" name="Immagine 10">
              <a:extLst>
                <a:ext uri="{FF2B5EF4-FFF2-40B4-BE49-F238E27FC236}">
                  <a16:creationId xmlns:a16="http://schemas.microsoft.com/office/drawing/2014/main" id="{55047B20-A26C-DAFB-947B-C6EFA8E6CAA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475745" y="581548"/>
              <a:ext cx="2890947" cy="1574078"/>
            </a:xfrm>
            <a:prstGeom prst="rect">
              <a:avLst/>
            </a:prstGeom>
          </p:spPr>
        </p:pic>
        <p:pic>
          <p:nvPicPr>
            <p:cNvPr id="12" name="Immagine 11">
              <a:extLst>
                <a:ext uri="{FF2B5EF4-FFF2-40B4-BE49-F238E27FC236}">
                  <a16:creationId xmlns:a16="http://schemas.microsoft.com/office/drawing/2014/main" id="{784099A1-20E1-4F54-3CA7-ABED85F0A8B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91308" y="2472083"/>
              <a:ext cx="2984437" cy="1723435"/>
            </a:xfrm>
            <a:prstGeom prst="rect">
              <a:avLst/>
            </a:prstGeom>
          </p:spPr>
        </p:pic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DE639872-EA93-444B-03B0-FC153088C006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28999" y="2397948"/>
              <a:ext cx="2890947" cy="1797570"/>
            </a:xfrm>
            <a:prstGeom prst="rect">
              <a:avLst/>
            </a:prstGeom>
          </p:spPr>
        </p:pic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A90DB188-0367-B598-409F-A1DD954E24FC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4123" y="4511975"/>
              <a:ext cx="2981622" cy="1956286"/>
            </a:xfrm>
            <a:prstGeom prst="rect">
              <a:avLst/>
            </a:prstGeom>
          </p:spPr>
        </p:pic>
        <p:pic>
          <p:nvPicPr>
            <p:cNvPr id="15" name="Immagine 14">
              <a:extLst>
                <a:ext uri="{FF2B5EF4-FFF2-40B4-BE49-F238E27FC236}">
                  <a16:creationId xmlns:a16="http://schemas.microsoft.com/office/drawing/2014/main" id="{C2B24A2E-84A9-B4EA-A886-D7887EB05CD0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472930" y="4511975"/>
              <a:ext cx="2890947" cy="195628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7287062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</TotalTime>
  <Words>38</Words>
  <Application>Microsoft Macintosh PowerPoint</Application>
  <PresentationFormat>A4 Paper (210x297 mm)</PresentationFormat>
  <Paragraphs>27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a Trespidi</dc:creator>
  <cp:lastModifiedBy>Alessandro Borghesi</cp:lastModifiedBy>
  <cp:revision>19</cp:revision>
  <dcterms:created xsi:type="dcterms:W3CDTF">2025-06-23T10:32:05Z</dcterms:created>
  <dcterms:modified xsi:type="dcterms:W3CDTF">2025-08-20T13:29:48Z</dcterms:modified>
</cp:coreProperties>
</file>